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7200900"/>
  <p:notesSz cx="9144000" cy="6858000"/>
  <p:defaultTextStyle>
    <a:defPPr>
      <a:defRPr lang="es-PE"/>
    </a:defPPr>
    <a:lvl1pPr marL="0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09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20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29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39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48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659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768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879" algn="l" defTabSz="91422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34587" autoAdjust="0"/>
    <p:restoredTop sz="94692" autoAdjust="0"/>
  </p:normalViewPr>
  <p:slideViewPr>
    <p:cSldViewPr>
      <p:cViewPr>
        <p:scale>
          <a:sx n="70" d="100"/>
          <a:sy n="70" d="100"/>
        </p:scale>
        <p:origin x="-1666" y="-293"/>
      </p:cViewPr>
      <p:guideLst>
        <p:guide orient="horz" pos="2268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P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D1F3C6-0068-4F44-AA2B-72BC55786C21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40050" y="514350"/>
            <a:ext cx="32639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P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P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591FE-BA8A-492E-B0BD-6B614F4E2F05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19769629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09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20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29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39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548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659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768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879" algn="l" defTabSz="91422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938463" y="514350"/>
            <a:ext cx="3267075" cy="25717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P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2591FE-BA8A-492E-B0BD-6B614F4E2F05}" type="slidenum">
              <a:rPr lang="es-PE" smtClean="0"/>
              <a:t>1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2124062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4" y="2236949"/>
            <a:ext cx="7772400" cy="154353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080510"/>
            <a:ext cx="6400800" cy="1840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6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7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8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P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2324509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528663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3" y="288374"/>
            <a:ext cx="2057401" cy="614410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5" y="288374"/>
            <a:ext cx="6019801" cy="614410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860145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2142851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4" y="4627248"/>
            <a:ext cx="7772400" cy="143017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4" y="3052055"/>
            <a:ext cx="7772400" cy="157519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2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4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65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76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8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2751686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2" y="1680218"/>
            <a:ext cx="4038601" cy="47522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5" y="1680218"/>
            <a:ext cx="4038601" cy="47522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1647107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11871"/>
            <a:ext cx="4040188" cy="6717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9" indent="0">
              <a:buNone/>
              <a:defRPr sz="2000" b="1"/>
            </a:lvl2pPr>
            <a:lvl3pPr marL="914220" indent="0">
              <a:buNone/>
              <a:defRPr sz="1800" b="1"/>
            </a:lvl3pPr>
            <a:lvl4pPr marL="1371329" indent="0">
              <a:buNone/>
              <a:defRPr sz="1600" b="1"/>
            </a:lvl4pPr>
            <a:lvl5pPr marL="1828439" indent="0">
              <a:buNone/>
              <a:defRPr sz="1600" b="1"/>
            </a:lvl5pPr>
            <a:lvl6pPr marL="2285548" indent="0">
              <a:buNone/>
              <a:defRPr sz="1600" b="1"/>
            </a:lvl6pPr>
            <a:lvl7pPr marL="2742659" indent="0">
              <a:buNone/>
              <a:defRPr sz="1600" b="1"/>
            </a:lvl7pPr>
            <a:lvl8pPr marL="3199768" indent="0">
              <a:buNone/>
              <a:defRPr sz="1600" b="1"/>
            </a:lvl8pPr>
            <a:lvl9pPr marL="365687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283624"/>
            <a:ext cx="4040188" cy="414884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611871"/>
            <a:ext cx="4041774" cy="6717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9" indent="0">
              <a:buNone/>
              <a:defRPr sz="2000" b="1"/>
            </a:lvl2pPr>
            <a:lvl3pPr marL="914220" indent="0">
              <a:buNone/>
              <a:defRPr sz="1800" b="1"/>
            </a:lvl3pPr>
            <a:lvl4pPr marL="1371329" indent="0">
              <a:buNone/>
              <a:defRPr sz="1600" b="1"/>
            </a:lvl4pPr>
            <a:lvl5pPr marL="1828439" indent="0">
              <a:buNone/>
              <a:defRPr sz="1600" b="1"/>
            </a:lvl5pPr>
            <a:lvl6pPr marL="2285548" indent="0">
              <a:buNone/>
              <a:defRPr sz="1600" b="1"/>
            </a:lvl6pPr>
            <a:lvl7pPr marL="2742659" indent="0">
              <a:buNone/>
              <a:defRPr sz="1600" b="1"/>
            </a:lvl7pPr>
            <a:lvl8pPr marL="3199768" indent="0">
              <a:buNone/>
              <a:defRPr sz="1600" b="1"/>
            </a:lvl8pPr>
            <a:lvl9pPr marL="365687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283624"/>
            <a:ext cx="4041774" cy="414884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193861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3460806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2175079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86705"/>
            <a:ext cx="3008313" cy="12201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2" y="286709"/>
            <a:ext cx="5111751" cy="614576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506861"/>
            <a:ext cx="3008313" cy="4925616"/>
          </a:xfrm>
        </p:spPr>
        <p:txBody>
          <a:bodyPr/>
          <a:lstStyle>
            <a:lvl1pPr marL="0" indent="0">
              <a:buNone/>
              <a:defRPr sz="1400"/>
            </a:lvl1pPr>
            <a:lvl2pPr marL="457109" indent="0">
              <a:buNone/>
              <a:defRPr sz="1200"/>
            </a:lvl2pPr>
            <a:lvl3pPr marL="914220" indent="0">
              <a:buNone/>
              <a:defRPr sz="1000"/>
            </a:lvl3pPr>
            <a:lvl4pPr marL="1371329" indent="0">
              <a:buNone/>
              <a:defRPr sz="1000"/>
            </a:lvl4pPr>
            <a:lvl5pPr marL="1828439" indent="0">
              <a:buNone/>
              <a:defRPr sz="1000"/>
            </a:lvl5pPr>
            <a:lvl6pPr marL="2285548" indent="0">
              <a:buNone/>
              <a:defRPr sz="1000"/>
            </a:lvl6pPr>
            <a:lvl7pPr marL="2742659" indent="0">
              <a:buNone/>
              <a:defRPr sz="1000"/>
            </a:lvl7pPr>
            <a:lvl8pPr marL="3199768" indent="0">
              <a:buNone/>
              <a:defRPr sz="1000"/>
            </a:lvl8pPr>
            <a:lvl9pPr marL="3656879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3431674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040634"/>
            <a:ext cx="5486400" cy="59507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43411"/>
            <a:ext cx="5486400" cy="4320540"/>
          </a:xfrm>
        </p:spPr>
        <p:txBody>
          <a:bodyPr/>
          <a:lstStyle>
            <a:lvl1pPr marL="0" indent="0">
              <a:buNone/>
              <a:defRPr sz="3200"/>
            </a:lvl1pPr>
            <a:lvl2pPr marL="457109" indent="0">
              <a:buNone/>
              <a:defRPr sz="2800"/>
            </a:lvl2pPr>
            <a:lvl3pPr marL="914220" indent="0">
              <a:buNone/>
              <a:defRPr sz="2400"/>
            </a:lvl3pPr>
            <a:lvl4pPr marL="1371329" indent="0">
              <a:buNone/>
              <a:defRPr sz="2000"/>
            </a:lvl4pPr>
            <a:lvl5pPr marL="1828439" indent="0">
              <a:buNone/>
              <a:defRPr sz="2000"/>
            </a:lvl5pPr>
            <a:lvl6pPr marL="2285548" indent="0">
              <a:buNone/>
              <a:defRPr sz="2000"/>
            </a:lvl6pPr>
            <a:lvl7pPr marL="2742659" indent="0">
              <a:buNone/>
              <a:defRPr sz="2000"/>
            </a:lvl7pPr>
            <a:lvl8pPr marL="3199768" indent="0">
              <a:buNone/>
              <a:defRPr sz="2000"/>
            </a:lvl8pPr>
            <a:lvl9pPr marL="3656879" indent="0">
              <a:buNone/>
              <a:defRPr sz="2000"/>
            </a:lvl9pPr>
          </a:lstStyle>
          <a:p>
            <a:endParaRPr lang="es-P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635708"/>
            <a:ext cx="5486400" cy="845106"/>
          </a:xfrm>
        </p:spPr>
        <p:txBody>
          <a:bodyPr/>
          <a:lstStyle>
            <a:lvl1pPr marL="0" indent="0">
              <a:buNone/>
              <a:defRPr sz="1400"/>
            </a:lvl1pPr>
            <a:lvl2pPr marL="457109" indent="0">
              <a:buNone/>
              <a:defRPr sz="1200"/>
            </a:lvl2pPr>
            <a:lvl3pPr marL="914220" indent="0">
              <a:buNone/>
              <a:defRPr sz="1000"/>
            </a:lvl3pPr>
            <a:lvl4pPr marL="1371329" indent="0">
              <a:buNone/>
              <a:defRPr sz="1000"/>
            </a:lvl4pPr>
            <a:lvl5pPr marL="1828439" indent="0">
              <a:buNone/>
              <a:defRPr sz="1000"/>
            </a:lvl5pPr>
            <a:lvl6pPr marL="2285548" indent="0">
              <a:buNone/>
              <a:defRPr sz="1000"/>
            </a:lvl6pPr>
            <a:lvl7pPr marL="2742659" indent="0">
              <a:buNone/>
              <a:defRPr sz="1000"/>
            </a:lvl7pPr>
            <a:lvl8pPr marL="3199768" indent="0">
              <a:buNone/>
              <a:defRPr sz="1000"/>
            </a:lvl8pPr>
            <a:lvl9pPr marL="3656879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P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60656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88375"/>
            <a:ext cx="8229600" cy="1200150"/>
          </a:xfrm>
          <a:prstGeom prst="rect">
            <a:avLst/>
          </a:prstGeom>
        </p:spPr>
        <p:txBody>
          <a:bodyPr vert="horz" lIns="91422" tIns="45710" rIns="91422" bIns="4571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P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80218"/>
            <a:ext cx="8229600" cy="4752263"/>
          </a:xfrm>
          <a:prstGeom prst="rect">
            <a:avLst/>
          </a:prstGeom>
        </p:spPr>
        <p:txBody>
          <a:bodyPr vert="horz" lIns="91422" tIns="45710" rIns="91422" bIns="4571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P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674165"/>
            <a:ext cx="2133600" cy="383387"/>
          </a:xfrm>
          <a:prstGeom prst="rect">
            <a:avLst/>
          </a:prstGeom>
        </p:spPr>
        <p:txBody>
          <a:bodyPr vert="horz" lIns="91422" tIns="45710" rIns="91422" bIns="4571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76DF32-919B-4135-8806-AF5CA73F9F92}" type="datetimeFigureOut">
              <a:rPr lang="es-PE" smtClean="0"/>
              <a:t>06/06/2014</a:t>
            </a:fld>
            <a:endParaRPr lang="es-P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4" y="6674165"/>
            <a:ext cx="2895600" cy="383387"/>
          </a:xfrm>
          <a:prstGeom prst="rect">
            <a:avLst/>
          </a:prstGeom>
        </p:spPr>
        <p:txBody>
          <a:bodyPr vert="horz" lIns="91422" tIns="45710" rIns="91422" bIns="4571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P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674165"/>
            <a:ext cx="2133600" cy="383387"/>
          </a:xfrm>
          <a:prstGeom prst="rect">
            <a:avLst/>
          </a:prstGeom>
        </p:spPr>
        <p:txBody>
          <a:bodyPr vert="horz" lIns="91422" tIns="45710" rIns="91422" bIns="4571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473D6-C4CA-4CCF-9650-327D7F862E47}" type="slidenum">
              <a:rPr lang="es-PE" smtClean="0"/>
              <a:t>‹#›</a:t>
            </a:fld>
            <a:endParaRPr lang="es-PE"/>
          </a:p>
        </p:txBody>
      </p:sp>
    </p:spTree>
    <p:extLst>
      <p:ext uri="{BB962C8B-B14F-4D97-AF65-F5344CB8AC3E}">
        <p14:creationId xmlns:p14="http://schemas.microsoft.com/office/powerpoint/2010/main" val="33076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2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3" indent="-342833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03" indent="-285695" algn="l" defTabSz="9142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74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85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94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05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14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24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33" indent="-228554" algn="l" defTabSz="9142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PE"/>
      </a:defPPr>
      <a:lvl1pPr marL="0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09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20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29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39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48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659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68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879" algn="l" defTabSz="91422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108574" y="2480286"/>
            <a:ext cx="3089144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80 (7.3%) patients who were initially admitted to either a general bay or to the TB cohorting bay AND were eventually transferred to the other one during hospitalization</a:t>
            </a:r>
            <a:endParaRPr lang="es-PE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453468" y="2421623"/>
            <a:ext cx="1980221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131 (12%) patients admitted directly to the TB cohorting bay and remained there until dead or discharge</a:t>
            </a:r>
            <a:endParaRPr lang="es-PE" sz="1100" dirty="0"/>
          </a:p>
        </p:txBody>
      </p:sp>
      <p:grpSp>
        <p:nvGrpSpPr>
          <p:cNvPr id="25" name="Group 24"/>
          <p:cNvGrpSpPr/>
          <p:nvPr/>
        </p:nvGrpSpPr>
        <p:grpSpPr>
          <a:xfrm>
            <a:off x="3090834" y="342079"/>
            <a:ext cx="7729889" cy="1490622"/>
            <a:chOff x="2142892" y="64924"/>
            <a:chExt cx="5533898" cy="1720780"/>
          </a:xfrm>
        </p:grpSpPr>
        <p:sp>
          <p:nvSpPr>
            <p:cNvPr id="4" name="TextBox 3"/>
            <p:cNvSpPr txBox="1"/>
            <p:nvPr/>
          </p:nvSpPr>
          <p:spPr>
            <a:xfrm>
              <a:off x="2142892" y="99584"/>
              <a:ext cx="2211546" cy="49741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,283 patients eligible to be admitted to the Medical Wards</a:t>
              </a:r>
              <a:endParaRPr lang="es-PE" sz="11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25496" y="64924"/>
              <a:ext cx="1751294" cy="166990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ZA" sz="1100" dirty="0"/>
                <a:t>189 (6.8%) patients died at the Emergency Department before admission to the medical wards:</a:t>
              </a:r>
            </a:p>
            <a:p>
              <a:r>
                <a:rPr lang="en-ZA" sz="1100" dirty="0"/>
                <a:t>Pneumonia: 34 (18%)</a:t>
              </a:r>
            </a:p>
            <a:p>
              <a:r>
                <a:rPr lang="en-ZA" sz="1100" dirty="0"/>
                <a:t>   - Suspected TB: 16</a:t>
              </a:r>
            </a:p>
            <a:p>
              <a:r>
                <a:rPr lang="en-ZA" sz="1100" dirty="0"/>
                <a:t>   - Confirmed TB: 4</a:t>
              </a:r>
            </a:p>
            <a:p>
              <a:r>
                <a:rPr lang="en-ZA" sz="1100" dirty="0"/>
                <a:t>EPTB: 8 (4.2%)</a:t>
              </a:r>
            </a:p>
            <a:p>
              <a:r>
                <a:rPr lang="en-ZA" sz="1100" dirty="0"/>
                <a:t>Other diagnosis 147 (77.8%)</a:t>
              </a:r>
              <a:endParaRPr lang="es-PE" sz="11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55592" y="1288286"/>
              <a:ext cx="2211546" cy="49741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,094 patients were admitted to the Medical Wards </a:t>
              </a:r>
              <a:endParaRPr lang="es-PE" sz="1100" dirty="0"/>
            </a:p>
          </p:txBody>
        </p:sp>
        <p:cxnSp>
          <p:nvCxnSpPr>
            <p:cNvPr id="22" name="Straight Arrow Connector 21"/>
            <p:cNvCxnSpPr>
              <a:stCxn id="4" idx="2"/>
              <a:endCxn id="6" idx="0"/>
            </p:cNvCxnSpPr>
            <p:nvPr/>
          </p:nvCxnSpPr>
          <p:spPr>
            <a:xfrm>
              <a:off x="3248665" y="597002"/>
              <a:ext cx="12700" cy="69128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Elbow Connector 23"/>
            <p:cNvCxnSpPr>
              <a:stCxn id="4" idx="2"/>
              <a:endCxn id="5" idx="1"/>
            </p:cNvCxnSpPr>
            <p:nvPr/>
          </p:nvCxnSpPr>
          <p:spPr>
            <a:xfrm rot="16200000" flipH="1">
              <a:off x="4435643" y="-589977"/>
              <a:ext cx="302874" cy="2676831"/>
            </a:xfrm>
            <a:prstGeom prst="bentConnector2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Box 13"/>
          <p:cNvSpPr txBox="1"/>
          <p:nvPr/>
        </p:nvSpPr>
        <p:spPr>
          <a:xfrm>
            <a:off x="-1052376" y="3745744"/>
            <a:ext cx="1980221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3 (2.3%) patients were ruled out for active TB infection</a:t>
            </a:r>
            <a:endParaRPr lang="es-PE" sz="1100" dirty="0"/>
          </a:p>
          <a:p>
            <a:pPr algn="ctr"/>
            <a:endParaRPr lang="es-PE" sz="1100" dirty="0"/>
          </a:p>
          <a:p>
            <a:pPr algn="ctr"/>
            <a:endParaRPr lang="es-PE" sz="1100" dirty="0"/>
          </a:p>
        </p:txBody>
      </p:sp>
      <p:sp>
        <p:nvSpPr>
          <p:cNvPr id="16" name="TextBox 15"/>
          <p:cNvSpPr txBox="1"/>
          <p:nvPr/>
        </p:nvSpPr>
        <p:spPr>
          <a:xfrm>
            <a:off x="-5550140" y="3745744"/>
            <a:ext cx="1980221" cy="6001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115 (87.8%) patients were confirmed to have TB microbiologically</a:t>
            </a:r>
            <a:endParaRPr lang="es-PE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-3230212" y="3745744"/>
            <a:ext cx="1831663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13 (9.9%) patients were diagnosed with TB based on clinical, radiographic or therapeutic grounds</a:t>
            </a:r>
            <a:endParaRPr lang="es-PE" sz="1100" dirty="0"/>
          </a:p>
        </p:txBody>
      </p:sp>
      <p:grpSp>
        <p:nvGrpSpPr>
          <p:cNvPr id="39" name="Group 38"/>
          <p:cNvGrpSpPr/>
          <p:nvPr/>
        </p:nvGrpSpPr>
        <p:grpSpPr>
          <a:xfrm>
            <a:off x="-5556545" y="5071433"/>
            <a:ext cx="1986626" cy="1721525"/>
            <a:chOff x="-745827" y="5417133"/>
            <a:chExt cx="1422244" cy="1987335"/>
          </a:xfrm>
        </p:grpSpPr>
        <p:sp>
          <p:nvSpPr>
            <p:cNvPr id="11" name="TextBox 10"/>
            <p:cNvSpPr txBox="1"/>
            <p:nvPr/>
          </p:nvSpPr>
          <p:spPr>
            <a:xfrm>
              <a:off x="-741241" y="5417133"/>
              <a:ext cx="1417658" cy="88824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5 (13.1%) patients were diagnosed with new/relapse/recurrent TB during follow up</a:t>
              </a:r>
              <a:endParaRPr lang="es-PE" sz="11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-745827" y="6516222"/>
              <a:ext cx="1422244" cy="88824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0 (66.7%) patients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36" name="Straight Arrow Connector 35"/>
            <p:cNvCxnSpPr>
              <a:stCxn id="11" idx="2"/>
              <a:endCxn id="19" idx="0"/>
            </p:cNvCxnSpPr>
            <p:nvPr/>
          </p:nvCxnSpPr>
          <p:spPr>
            <a:xfrm flipH="1">
              <a:off x="-34705" y="6305379"/>
              <a:ext cx="2293" cy="21084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>
            <a:off x="-3307694" y="5078501"/>
            <a:ext cx="1986626" cy="1721524"/>
            <a:chOff x="-745827" y="5417133"/>
            <a:chExt cx="1422244" cy="1987332"/>
          </a:xfrm>
        </p:grpSpPr>
        <p:sp>
          <p:nvSpPr>
            <p:cNvPr id="41" name="TextBox 40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4 (30.8%) </a:t>
              </a:r>
              <a:r>
                <a:rPr lang="en-GB" sz="1100" dirty="0"/>
                <a:t>patients were diagnosed with new/relapse/recurrent TB during follow up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-745827" y="6516220"/>
              <a:ext cx="1422244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3 (75%) patients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48" name="Straight Arrow Connector 47"/>
            <p:cNvCxnSpPr>
              <a:stCxn id="41" idx="2"/>
              <a:endCxn id="45" idx="0"/>
            </p:cNvCxnSpPr>
            <p:nvPr/>
          </p:nvCxnSpPr>
          <p:spPr>
            <a:xfrm flipH="1">
              <a:off x="-34705" y="6305378"/>
              <a:ext cx="2293" cy="2108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 49"/>
          <p:cNvGrpSpPr/>
          <p:nvPr/>
        </p:nvGrpSpPr>
        <p:grpSpPr>
          <a:xfrm>
            <a:off x="-1058782" y="5064372"/>
            <a:ext cx="1986626" cy="1721524"/>
            <a:chOff x="-745827" y="5417133"/>
            <a:chExt cx="1422244" cy="1987332"/>
          </a:xfrm>
        </p:grpSpPr>
        <p:sp>
          <p:nvSpPr>
            <p:cNvPr id="51" name="TextBox 50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 (33.3%) </a:t>
              </a:r>
              <a:r>
                <a:rPr lang="en-GB" sz="1100" dirty="0"/>
                <a:t>patient was diagnosed with new/relapse/recurrent TB during follow up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-745827" y="6516220"/>
              <a:ext cx="1422244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No patient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58" name="Straight Arrow Connector 57"/>
            <p:cNvCxnSpPr>
              <a:stCxn id="51" idx="2"/>
              <a:endCxn id="55" idx="0"/>
            </p:cNvCxnSpPr>
            <p:nvPr/>
          </p:nvCxnSpPr>
          <p:spPr>
            <a:xfrm flipH="1">
              <a:off x="-34705" y="6305378"/>
              <a:ext cx="2293" cy="2108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9" name="Elbow Connector 78"/>
          <p:cNvCxnSpPr>
            <a:endCxn id="16" idx="0"/>
          </p:cNvCxnSpPr>
          <p:nvPr/>
        </p:nvCxnSpPr>
        <p:spPr>
          <a:xfrm rot="10800000" flipV="1">
            <a:off x="-4560029" y="3200302"/>
            <a:ext cx="5964006" cy="545442"/>
          </a:xfrm>
          <a:prstGeom prst="bentConnector2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Elbow Connector 80"/>
          <p:cNvCxnSpPr>
            <a:endCxn id="17" idx="0"/>
          </p:cNvCxnSpPr>
          <p:nvPr/>
        </p:nvCxnSpPr>
        <p:spPr>
          <a:xfrm rot="10800000" flipV="1">
            <a:off x="-2314379" y="3200284"/>
            <a:ext cx="3718365" cy="545460"/>
          </a:xfrm>
          <a:prstGeom prst="bentConnector2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Elbow Connector 82"/>
          <p:cNvCxnSpPr>
            <a:endCxn id="14" idx="0"/>
          </p:cNvCxnSpPr>
          <p:nvPr/>
        </p:nvCxnSpPr>
        <p:spPr>
          <a:xfrm rot="10800000" flipV="1">
            <a:off x="-62265" y="3200302"/>
            <a:ext cx="1466242" cy="545442"/>
          </a:xfrm>
          <a:prstGeom prst="bentConnector2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/>
          <p:cNvSpPr txBox="1"/>
          <p:nvPr/>
        </p:nvSpPr>
        <p:spPr>
          <a:xfrm>
            <a:off x="6004559" y="3745745"/>
            <a:ext cx="1656485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3 (3.8%) </a:t>
            </a:r>
            <a:r>
              <a:rPr lang="en-GB" sz="1100" dirty="0"/>
              <a:t>patients were ruled out for active TB infection</a:t>
            </a:r>
          </a:p>
          <a:p>
            <a:pPr algn="ctr"/>
            <a:endParaRPr lang="es-PE" sz="1100" dirty="0"/>
          </a:p>
        </p:txBody>
      </p:sp>
      <p:sp>
        <p:nvSpPr>
          <p:cNvPr id="160" name="TextBox 159"/>
          <p:cNvSpPr txBox="1"/>
          <p:nvPr/>
        </p:nvSpPr>
        <p:spPr>
          <a:xfrm>
            <a:off x="1505814" y="3761996"/>
            <a:ext cx="1824701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70 (87.5%) </a:t>
            </a:r>
            <a:r>
              <a:rPr lang="en-GB" sz="1100" dirty="0"/>
              <a:t>patients were confirmed to have TB microbiologically</a:t>
            </a:r>
          </a:p>
          <a:p>
            <a:pPr algn="ctr"/>
            <a:endParaRPr lang="es-PE" sz="1100" dirty="0"/>
          </a:p>
        </p:txBody>
      </p:sp>
      <p:sp>
        <p:nvSpPr>
          <p:cNvPr id="161" name="TextBox 160"/>
          <p:cNvSpPr txBox="1"/>
          <p:nvPr/>
        </p:nvSpPr>
        <p:spPr>
          <a:xfrm>
            <a:off x="3718632" y="3761996"/>
            <a:ext cx="1831663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7 (8.8%) </a:t>
            </a:r>
            <a:r>
              <a:rPr lang="en-GB" sz="1100" dirty="0"/>
              <a:t>patients were diagnosed with TB based on clinical, radiographic or therapeutic grounds</a:t>
            </a:r>
            <a:endParaRPr lang="es-PE" sz="1100" dirty="0"/>
          </a:p>
        </p:txBody>
      </p:sp>
      <p:grpSp>
        <p:nvGrpSpPr>
          <p:cNvPr id="165" name="Group 164"/>
          <p:cNvGrpSpPr/>
          <p:nvPr/>
        </p:nvGrpSpPr>
        <p:grpSpPr>
          <a:xfrm>
            <a:off x="1405232" y="5050527"/>
            <a:ext cx="1986626" cy="1721524"/>
            <a:chOff x="-745827" y="5417133"/>
            <a:chExt cx="1422244" cy="1987332"/>
          </a:xfrm>
        </p:grpSpPr>
        <p:sp>
          <p:nvSpPr>
            <p:cNvPr id="192" name="TextBox 191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0 (14.3%) </a:t>
              </a:r>
              <a:r>
                <a:rPr lang="en-GB" sz="1100" dirty="0"/>
                <a:t>patient was diagnosed with new/relapse/recurrent TB during follow up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-745827" y="6516220"/>
              <a:ext cx="1422244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6 (60%) patients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199" name="Straight Arrow Connector 198"/>
            <p:cNvCxnSpPr>
              <a:stCxn id="192" idx="2"/>
              <a:endCxn id="196" idx="0"/>
            </p:cNvCxnSpPr>
            <p:nvPr/>
          </p:nvCxnSpPr>
          <p:spPr>
            <a:xfrm flipH="1">
              <a:off x="-34705" y="6305378"/>
              <a:ext cx="2293" cy="2108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6" name="Group 165"/>
          <p:cNvGrpSpPr/>
          <p:nvPr/>
        </p:nvGrpSpPr>
        <p:grpSpPr>
          <a:xfrm>
            <a:off x="5837532" y="5050242"/>
            <a:ext cx="1986626" cy="1721524"/>
            <a:chOff x="-745827" y="5417133"/>
            <a:chExt cx="1422244" cy="1987332"/>
          </a:xfrm>
        </p:grpSpPr>
        <p:sp>
          <p:nvSpPr>
            <p:cNvPr id="183" name="TextBox 182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 (33.3%) </a:t>
              </a:r>
              <a:r>
                <a:rPr lang="en-GB" sz="1100" dirty="0"/>
                <a:t>patient was diagnosed with new/relapse/recurrent TB during follow up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-745827" y="6516220"/>
              <a:ext cx="1422244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No patients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190" name="Straight Arrow Connector 189"/>
            <p:cNvCxnSpPr>
              <a:stCxn id="183" idx="2"/>
              <a:endCxn id="187" idx="0"/>
            </p:cNvCxnSpPr>
            <p:nvPr/>
          </p:nvCxnSpPr>
          <p:spPr>
            <a:xfrm flipH="1">
              <a:off x="-34705" y="6305378"/>
              <a:ext cx="2293" cy="2108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/>
          <p:cNvSpPr txBox="1"/>
          <p:nvPr/>
        </p:nvSpPr>
        <p:spPr>
          <a:xfrm>
            <a:off x="7107008" y="2446407"/>
            <a:ext cx="2059429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883 (80.7%) patients were </a:t>
            </a:r>
            <a:r>
              <a:rPr lang="en-GB" sz="1100" dirty="0"/>
              <a:t>admitted directly to the general medicine bays and remained there until dead or discharge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2742282" y="3750163"/>
            <a:ext cx="1994069" cy="6001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873 (98.8%) never presented clinical evidence of TB or were ruled out for TB infection</a:t>
            </a:r>
            <a:endParaRPr lang="es-PE" sz="1100" dirty="0"/>
          </a:p>
        </p:txBody>
      </p:sp>
      <p:sp>
        <p:nvSpPr>
          <p:cNvPr id="86" name="TextBox 85"/>
          <p:cNvSpPr txBox="1"/>
          <p:nvPr/>
        </p:nvSpPr>
        <p:spPr>
          <a:xfrm>
            <a:off x="8248378" y="3750163"/>
            <a:ext cx="1986626" cy="4308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6 (0.7%) patients had a microbiological diagnosis of TB</a:t>
            </a:r>
            <a:endParaRPr lang="es-PE" sz="1100" dirty="0"/>
          </a:p>
        </p:txBody>
      </p:sp>
      <p:sp>
        <p:nvSpPr>
          <p:cNvPr id="87" name="TextBox 86"/>
          <p:cNvSpPr txBox="1"/>
          <p:nvPr/>
        </p:nvSpPr>
        <p:spPr>
          <a:xfrm>
            <a:off x="10506991" y="3750163"/>
            <a:ext cx="1977271" cy="7694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ZA" sz="1100" dirty="0"/>
              <a:t> 4 (0.5) patients were clinically diagnosed with TB and started on treatment</a:t>
            </a:r>
          </a:p>
          <a:p>
            <a:pPr algn="ctr"/>
            <a:endParaRPr lang="es-PE" sz="1100" dirty="0"/>
          </a:p>
        </p:txBody>
      </p:sp>
      <p:cxnSp>
        <p:nvCxnSpPr>
          <p:cNvPr id="216" name="Elbow Connector 215"/>
          <p:cNvCxnSpPr>
            <a:stCxn id="8" idx="2"/>
            <a:endCxn id="160" idx="0"/>
          </p:cNvCxnSpPr>
          <p:nvPr/>
        </p:nvCxnSpPr>
        <p:spPr>
          <a:xfrm rot="5400000">
            <a:off x="3279522" y="2388371"/>
            <a:ext cx="512269" cy="2234981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Elbow Connector 230"/>
          <p:cNvCxnSpPr>
            <a:stCxn id="6" idx="2"/>
            <a:endCxn id="9" idx="0"/>
          </p:cNvCxnSpPr>
          <p:nvPr/>
        </p:nvCxnSpPr>
        <p:spPr>
          <a:xfrm rot="5400000">
            <a:off x="2753902" y="522379"/>
            <a:ext cx="588922" cy="3209567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Elbow Connector 234"/>
          <p:cNvCxnSpPr>
            <a:stCxn id="6" idx="2"/>
            <a:endCxn id="7" idx="0"/>
          </p:cNvCxnSpPr>
          <p:nvPr/>
        </p:nvCxnSpPr>
        <p:spPr>
          <a:xfrm rot="16200000" flipH="1">
            <a:off x="6088081" y="397765"/>
            <a:ext cx="613706" cy="3483577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Arrow Connector 242"/>
          <p:cNvCxnSpPr>
            <a:stCxn id="6" idx="2"/>
            <a:endCxn id="8" idx="0"/>
          </p:cNvCxnSpPr>
          <p:nvPr/>
        </p:nvCxnSpPr>
        <p:spPr>
          <a:xfrm>
            <a:off x="4653146" y="1832701"/>
            <a:ext cx="0" cy="64758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Arrow Connector 200"/>
          <p:cNvCxnSpPr>
            <a:stCxn id="17" idx="2"/>
            <a:endCxn id="41" idx="0"/>
          </p:cNvCxnSpPr>
          <p:nvPr/>
        </p:nvCxnSpPr>
        <p:spPr>
          <a:xfrm>
            <a:off x="-2314380" y="4515185"/>
            <a:ext cx="3202" cy="56331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Arrow Connector 201"/>
          <p:cNvCxnSpPr>
            <a:stCxn id="16" idx="2"/>
            <a:endCxn id="11" idx="0"/>
          </p:cNvCxnSpPr>
          <p:nvPr/>
        </p:nvCxnSpPr>
        <p:spPr>
          <a:xfrm>
            <a:off x="-4560029" y="4345908"/>
            <a:ext cx="0" cy="72552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Arrow Connector 202"/>
          <p:cNvCxnSpPr>
            <a:stCxn id="14" idx="2"/>
            <a:endCxn id="51" idx="0"/>
          </p:cNvCxnSpPr>
          <p:nvPr/>
        </p:nvCxnSpPr>
        <p:spPr>
          <a:xfrm flipH="1">
            <a:off x="-62266" y="4515185"/>
            <a:ext cx="1" cy="549187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4" name="Group 203"/>
          <p:cNvGrpSpPr/>
          <p:nvPr/>
        </p:nvGrpSpPr>
        <p:grpSpPr>
          <a:xfrm>
            <a:off x="3635788" y="5050529"/>
            <a:ext cx="1986626" cy="1552243"/>
            <a:chOff x="-745827" y="5417133"/>
            <a:chExt cx="1422244" cy="1791913"/>
          </a:xfrm>
        </p:grpSpPr>
        <p:sp>
          <p:nvSpPr>
            <p:cNvPr id="205" name="TextBox 204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 (14.3%) </a:t>
              </a:r>
              <a:r>
                <a:rPr lang="en-GB" sz="1100" dirty="0"/>
                <a:t>patient was diagnosed with new/relapse/recurrent TB during follow up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-745827" y="6516215"/>
              <a:ext cx="1422244" cy="69283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o patients died from confirmed or suspected TB (during follow up</a:t>
              </a:r>
              <a:endParaRPr lang="es-PE" sz="1100" dirty="0"/>
            </a:p>
          </p:txBody>
        </p:sp>
        <p:cxnSp>
          <p:nvCxnSpPr>
            <p:cNvPr id="207" name="Straight Arrow Connector 206"/>
            <p:cNvCxnSpPr>
              <a:stCxn id="205" idx="2"/>
              <a:endCxn id="206" idx="0"/>
            </p:cNvCxnSpPr>
            <p:nvPr/>
          </p:nvCxnSpPr>
          <p:spPr>
            <a:xfrm flipH="1">
              <a:off x="-34705" y="6305378"/>
              <a:ext cx="2293" cy="21083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9" name="Elbow Connector 208"/>
          <p:cNvCxnSpPr>
            <a:stCxn id="8" idx="2"/>
            <a:endCxn id="159" idx="0"/>
          </p:cNvCxnSpPr>
          <p:nvPr/>
        </p:nvCxnSpPr>
        <p:spPr>
          <a:xfrm rot="16200000" flipH="1">
            <a:off x="5494965" y="2407908"/>
            <a:ext cx="496018" cy="2179656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8" idx="2"/>
            <a:endCxn id="161" idx="0"/>
          </p:cNvCxnSpPr>
          <p:nvPr/>
        </p:nvCxnSpPr>
        <p:spPr>
          <a:xfrm flipH="1">
            <a:off x="4634464" y="3249727"/>
            <a:ext cx="18682" cy="51226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161" idx="2"/>
            <a:endCxn id="205" idx="0"/>
          </p:cNvCxnSpPr>
          <p:nvPr/>
        </p:nvCxnSpPr>
        <p:spPr>
          <a:xfrm flipH="1">
            <a:off x="4632304" y="4531437"/>
            <a:ext cx="2160" cy="51909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Arrow Connector 210"/>
          <p:cNvCxnSpPr>
            <a:stCxn id="160" idx="2"/>
            <a:endCxn id="192" idx="0"/>
          </p:cNvCxnSpPr>
          <p:nvPr/>
        </p:nvCxnSpPr>
        <p:spPr>
          <a:xfrm flipH="1">
            <a:off x="2401748" y="4531437"/>
            <a:ext cx="16418" cy="51909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Arrow Connector 212"/>
          <p:cNvCxnSpPr>
            <a:stCxn id="159" idx="2"/>
            <a:endCxn id="183" idx="0"/>
          </p:cNvCxnSpPr>
          <p:nvPr/>
        </p:nvCxnSpPr>
        <p:spPr>
          <a:xfrm>
            <a:off x="6832802" y="4515186"/>
            <a:ext cx="1246" cy="53505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5" name="Group 214"/>
          <p:cNvGrpSpPr/>
          <p:nvPr/>
        </p:nvGrpSpPr>
        <p:grpSpPr>
          <a:xfrm>
            <a:off x="8247205" y="5122802"/>
            <a:ext cx="1986626" cy="1721524"/>
            <a:chOff x="-745827" y="5417133"/>
            <a:chExt cx="1422244" cy="1987332"/>
          </a:xfrm>
        </p:grpSpPr>
        <p:sp>
          <p:nvSpPr>
            <p:cNvPr id="217" name="TextBox 216"/>
            <p:cNvSpPr txBox="1"/>
            <p:nvPr/>
          </p:nvSpPr>
          <p:spPr>
            <a:xfrm>
              <a:off x="-741241" y="5417133"/>
              <a:ext cx="1417658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2 (33.3%)</a:t>
              </a:r>
              <a:r>
                <a:rPr lang="en-GB" sz="1100" dirty="0"/>
                <a:t> patient was diagnosed with new/relapse/recurrent TB during follow up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-745827" y="6516220"/>
              <a:ext cx="1422244" cy="88824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1 (50%) patient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219" name="Straight Arrow Connector 218"/>
            <p:cNvCxnSpPr>
              <a:stCxn id="217" idx="2"/>
              <a:endCxn id="218" idx="0"/>
            </p:cNvCxnSpPr>
            <p:nvPr/>
          </p:nvCxnSpPr>
          <p:spPr>
            <a:xfrm flipH="1">
              <a:off x="-34705" y="6305378"/>
              <a:ext cx="2293" cy="2108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" name="Group 219"/>
          <p:cNvGrpSpPr/>
          <p:nvPr/>
        </p:nvGrpSpPr>
        <p:grpSpPr>
          <a:xfrm>
            <a:off x="10496057" y="5129870"/>
            <a:ext cx="1986626" cy="1552243"/>
            <a:chOff x="-745827" y="5417133"/>
            <a:chExt cx="1422244" cy="1791913"/>
          </a:xfrm>
        </p:grpSpPr>
        <p:sp>
          <p:nvSpPr>
            <p:cNvPr id="221" name="TextBox 220"/>
            <p:cNvSpPr txBox="1"/>
            <p:nvPr/>
          </p:nvSpPr>
          <p:spPr>
            <a:xfrm>
              <a:off x="-741241" y="5417133"/>
              <a:ext cx="1417658" cy="69283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 1 (25%)</a:t>
              </a:r>
              <a:r>
                <a:rPr lang="en-GB" sz="1100" dirty="0"/>
                <a:t> patient was diagnosed with new/relapse/recurrent TB during follow up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-745827" y="6516215"/>
              <a:ext cx="1422244" cy="69283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o patients died from confirmed or suspected TB (during follow up)</a:t>
              </a:r>
            </a:p>
          </p:txBody>
        </p:sp>
        <p:cxnSp>
          <p:nvCxnSpPr>
            <p:cNvPr id="223" name="Straight Arrow Connector 222"/>
            <p:cNvCxnSpPr>
              <a:stCxn id="221" idx="2"/>
              <a:endCxn id="222" idx="0"/>
            </p:cNvCxnSpPr>
            <p:nvPr/>
          </p:nvCxnSpPr>
          <p:spPr>
            <a:xfrm flipH="1">
              <a:off x="-34705" y="6109964"/>
              <a:ext cx="2293" cy="40625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Group 255"/>
          <p:cNvGrpSpPr/>
          <p:nvPr/>
        </p:nvGrpSpPr>
        <p:grpSpPr>
          <a:xfrm>
            <a:off x="12744970" y="5115736"/>
            <a:ext cx="1986626" cy="1721525"/>
            <a:chOff x="-745827" y="5417133"/>
            <a:chExt cx="1422244" cy="1987335"/>
          </a:xfrm>
        </p:grpSpPr>
        <p:sp>
          <p:nvSpPr>
            <p:cNvPr id="257" name="TextBox 256"/>
            <p:cNvSpPr txBox="1"/>
            <p:nvPr/>
          </p:nvSpPr>
          <p:spPr>
            <a:xfrm>
              <a:off x="-741241" y="5417133"/>
              <a:ext cx="1417658" cy="88824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 16 (18.3%) </a:t>
              </a:r>
              <a:r>
                <a:rPr lang="en-GB" sz="1100" dirty="0"/>
                <a:t>patient was diagnosed with new/relapse/recurrent TB during follow up</a:t>
              </a: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-745827" y="6516222"/>
              <a:ext cx="1422244" cy="88824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dirty="0"/>
                <a:t>6 (37.5%) patients died from confirmed or suspected TB (during follow up)</a:t>
              </a:r>
            </a:p>
            <a:p>
              <a:pPr algn="ctr"/>
              <a:endParaRPr lang="es-PE" sz="1100" dirty="0"/>
            </a:p>
          </p:txBody>
        </p:sp>
        <p:cxnSp>
          <p:nvCxnSpPr>
            <p:cNvPr id="259" name="Straight Arrow Connector 258"/>
            <p:cNvCxnSpPr>
              <a:stCxn id="257" idx="2"/>
              <a:endCxn id="258" idx="0"/>
            </p:cNvCxnSpPr>
            <p:nvPr/>
          </p:nvCxnSpPr>
          <p:spPr>
            <a:xfrm flipH="1">
              <a:off x="-34705" y="6305379"/>
              <a:ext cx="2293" cy="21084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0" name="Straight Arrow Connector 259"/>
          <p:cNvCxnSpPr>
            <a:stCxn id="87" idx="2"/>
            <a:endCxn id="221" idx="0"/>
          </p:cNvCxnSpPr>
          <p:nvPr/>
        </p:nvCxnSpPr>
        <p:spPr>
          <a:xfrm flipH="1">
            <a:off x="11492573" y="4519604"/>
            <a:ext cx="3054" cy="61026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Arrow Connector 260"/>
          <p:cNvCxnSpPr>
            <a:stCxn id="86" idx="2"/>
            <a:endCxn id="217" idx="0"/>
          </p:cNvCxnSpPr>
          <p:nvPr/>
        </p:nvCxnSpPr>
        <p:spPr>
          <a:xfrm>
            <a:off x="9241691" y="4181050"/>
            <a:ext cx="2030" cy="94175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Straight Arrow Connector 261"/>
          <p:cNvCxnSpPr>
            <a:stCxn id="85" idx="2"/>
            <a:endCxn id="257" idx="0"/>
          </p:cNvCxnSpPr>
          <p:nvPr/>
        </p:nvCxnSpPr>
        <p:spPr>
          <a:xfrm>
            <a:off x="13739317" y="4350327"/>
            <a:ext cx="2169" cy="76540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Elbow Connector 265"/>
          <p:cNvCxnSpPr>
            <a:stCxn id="7" idx="2"/>
            <a:endCxn id="86" idx="0"/>
          </p:cNvCxnSpPr>
          <p:nvPr/>
        </p:nvCxnSpPr>
        <p:spPr>
          <a:xfrm rot="16200000" flipH="1">
            <a:off x="8422050" y="2930520"/>
            <a:ext cx="534315" cy="1104968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Elbow Connector 267"/>
          <p:cNvCxnSpPr>
            <a:stCxn id="7" idx="2"/>
            <a:endCxn id="87" idx="0"/>
          </p:cNvCxnSpPr>
          <p:nvPr/>
        </p:nvCxnSpPr>
        <p:spPr>
          <a:xfrm rot="16200000" flipH="1">
            <a:off x="9549018" y="1803553"/>
            <a:ext cx="534315" cy="335890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Elbow Connector 269"/>
          <p:cNvCxnSpPr>
            <a:stCxn id="7" idx="2"/>
            <a:endCxn id="85" idx="0"/>
          </p:cNvCxnSpPr>
          <p:nvPr/>
        </p:nvCxnSpPr>
        <p:spPr>
          <a:xfrm rot="16200000" flipH="1">
            <a:off x="10670863" y="681708"/>
            <a:ext cx="534315" cy="560259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Rectangle 126"/>
          <p:cNvSpPr/>
          <p:nvPr/>
        </p:nvSpPr>
        <p:spPr>
          <a:xfrm>
            <a:off x="-7229785" y="213686"/>
            <a:ext cx="22257673" cy="720798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3200"/>
          </a:p>
        </p:txBody>
      </p:sp>
      <p:cxnSp>
        <p:nvCxnSpPr>
          <p:cNvPr id="129" name="Straight Connector 128"/>
          <p:cNvCxnSpPr/>
          <p:nvPr/>
        </p:nvCxnSpPr>
        <p:spPr>
          <a:xfrm flipV="1">
            <a:off x="-7229785" y="2035484"/>
            <a:ext cx="22257673" cy="847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Straight Connector 287"/>
          <p:cNvCxnSpPr/>
          <p:nvPr/>
        </p:nvCxnSpPr>
        <p:spPr>
          <a:xfrm flipV="1">
            <a:off x="-7229785" y="4728578"/>
            <a:ext cx="22257673" cy="1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-7071367" y="372105"/>
            <a:ext cx="5603778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Before admission:</a:t>
            </a:r>
          </a:p>
          <a:p>
            <a:r>
              <a:rPr lang="en-GB" sz="1400" dirty="0"/>
              <a:t>189 (6.8%) patients died before admission (in the Emergency Department)</a:t>
            </a:r>
          </a:p>
          <a:p>
            <a:r>
              <a:rPr lang="en-GB" sz="1400" dirty="0"/>
              <a:t>Of them, 20 (10.6%) died form suspected or confirmed TB </a:t>
            </a:r>
          </a:p>
        </p:txBody>
      </p:sp>
      <p:sp>
        <p:nvSpPr>
          <p:cNvPr id="289" name="TextBox 288"/>
          <p:cNvSpPr txBox="1"/>
          <p:nvPr/>
        </p:nvSpPr>
        <p:spPr>
          <a:xfrm>
            <a:off x="-7071367" y="2193904"/>
            <a:ext cx="6926690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During hospitalization:</a:t>
            </a:r>
          </a:p>
          <a:p>
            <a:r>
              <a:rPr lang="en-GB" sz="1200" dirty="0"/>
              <a:t>12 (5.6%) of the 215 patients who were diagnosed with TB during their admission died before discharge.  Considering that 178 (16.3%) of the 1,094 inpatients died before discharge, 6.7% (12 of 178) of the inpatient period mortality was attributable to TB.  14 (7.9%) additional patients died with pneumonia of undetermined aetiology. </a:t>
            </a:r>
          </a:p>
        </p:txBody>
      </p:sp>
      <p:sp>
        <p:nvSpPr>
          <p:cNvPr id="290" name="TextBox 289"/>
          <p:cNvSpPr txBox="1"/>
          <p:nvPr/>
        </p:nvSpPr>
        <p:spPr>
          <a:xfrm>
            <a:off x="-7071367" y="4807783"/>
            <a:ext cx="1435613" cy="2185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During follow-up: </a:t>
            </a:r>
            <a:r>
              <a:rPr lang="en-GB" sz="1200" dirty="0"/>
              <a:t>Of the 916 patients  who were eventually discharged for the Medical Wards, 51 (5.6%) developed TB during the  first year of follow up.  Of them 26 (51%) died.</a:t>
            </a:r>
          </a:p>
        </p:txBody>
      </p:sp>
    </p:spTree>
    <p:extLst>
      <p:ext uri="{BB962C8B-B14F-4D97-AF65-F5344CB8AC3E}">
        <p14:creationId xmlns:p14="http://schemas.microsoft.com/office/powerpoint/2010/main" val="4281398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/>
          <p:cNvGrpSpPr/>
          <p:nvPr/>
        </p:nvGrpSpPr>
        <p:grpSpPr>
          <a:xfrm>
            <a:off x="251520" y="360090"/>
            <a:ext cx="8196708" cy="5208413"/>
            <a:chOff x="251520" y="360090"/>
            <a:chExt cx="8196708" cy="5208413"/>
          </a:xfrm>
        </p:grpSpPr>
        <p:grpSp>
          <p:nvGrpSpPr>
            <p:cNvPr id="2" name="Group 1"/>
            <p:cNvGrpSpPr/>
            <p:nvPr/>
          </p:nvGrpSpPr>
          <p:grpSpPr>
            <a:xfrm>
              <a:off x="1327403" y="1952915"/>
              <a:ext cx="7045399" cy="1490622"/>
              <a:chOff x="2155592" y="64924"/>
              <a:chExt cx="5043868" cy="1720780"/>
            </a:xfrm>
            <a:solidFill>
              <a:schemeClr val="bg1">
                <a:lumMod val="75000"/>
              </a:schemeClr>
            </a:solidFill>
          </p:grpSpPr>
          <p:sp>
            <p:nvSpPr>
              <p:cNvPr id="3" name="TextBox 2"/>
              <p:cNvSpPr txBox="1"/>
              <p:nvPr/>
            </p:nvSpPr>
            <p:spPr>
              <a:xfrm>
                <a:off x="2156530" y="99584"/>
                <a:ext cx="2211546" cy="497418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,283 patients eligible to be admitted to the Medical Wards</a:t>
                </a:r>
                <a:endParaRPr lang="es-PE" sz="1100" b="1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5448166" y="64924"/>
                <a:ext cx="1751294" cy="1669903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ZA" sz="1100" b="1" dirty="0"/>
                  <a:t>189 (6.8%) patients died at the Emergency Department before admission to the medical wards:</a:t>
                </a:r>
              </a:p>
              <a:p>
                <a:r>
                  <a:rPr lang="en-ZA" sz="1100" b="1" dirty="0"/>
                  <a:t>Pneumonia: 34 (18%)</a:t>
                </a:r>
              </a:p>
              <a:p>
                <a:r>
                  <a:rPr lang="en-ZA" sz="1100" b="1" dirty="0"/>
                  <a:t>   - Suspected TB: 16</a:t>
                </a:r>
              </a:p>
              <a:p>
                <a:r>
                  <a:rPr lang="en-ZA" sz="1100" b="1" dirty="0"/>
                  <a:t>   - Confirmed TB: 4</a:t>
                </a:r>
              </a:p>
              <a:p>
                <a:r>
                  <a:rPr lang="en-ZA" sz="1100" b="1" dirty="0"/>
                  <a:t>EPTB: 8 (4.2%)</a:t>
                </a:r>
              </a:p>
              <a:p>
                <a:r>
                  <a:rPr lang="en-ZA" sz="1100" b="1" dirty="0"/>
                  <a:t>Other diagnosis 147 (77.8%)</a:t>
                </a:r>
                <a:endParaRPr lang="es-PE" sz="1100" b="1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155592" y="1288286"/>
                <a:ext cx="2211546" cy="497418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,094 patients were admitted to the Medical Wards </a:t>
                </a:r>
                <a:endParaRPr lang="es-PE" sz="1100" b="1" dirty="0"/>
              </a:p>
            </p:txBody>
          </p:sp>
          <p:cxnSp>
            <p:nvCxnSpPr>
              <p:cNvPr id="6" name="Straight Arrow Connector 5"/>
              <p:cNvCxnSpPr>
                <a:stCxn id="3" idx="2"/>
                <a:endCxn id="5" idx="0"/>
              </p:cNvCxnSpPr>
              <p:nvPr/>
            </p:nvCxnSpPr>
            <p:spPr>
              <a:xfrm flipH="1">
                <a:off x="3261365" y="597002"/>
                <a:ext cx="938" cy="691285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Elbow Connector 6"/>
              <p:cNvCxnSpPr>
                <a:stCxn id="3" idx="2"/>
                <a:endCxn id="4" idx="1"/>
              </p:cNvCxnSpPr>
              <p:nvPr/>
            </p:nvCxnSpPr>
            <p:spPr>
              <a:xfrm rot="16200000" flipH="1">
                <a:off x="4203797" y="-344493"/>
                <a:ext cx="302874" cy="2185863"/>
              </a:xfrm>
              <a:prstGeom prst="bentConnector2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7"/>
            <p:cNvSpPr txBox="1"/>
            <p:nvPr/>
          </p:nvSpPr>
          <p:spPr>
            <a:xfrm>
              <a:off x="324451" y="958801"/>
              <a:ext cx="5696752" cy="769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u="sng" dirty="0"/>
                <a:t>Before admission:</a:t>
              </a:r>
            </a:p>
            <a:p>
              <a:r>
                <a:rPr lang="en-GB" sz="1400" b="1" dirty="0"/>
                <a:t>189 (6.8%) patients died before admission (in the Emergency Department)</a:t>
              </a:r>
            </a:p>
            <a:p>
              <a:r>
                <a:rPr lang="en-GB" sz="1400" b="1" dirty="0"/>
                <a:t>Of them, 20 (10.6%) died form suspected or confirmed TB 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49724" y="4286622"/>
              <a:ext cx="3089144" cy="769441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80 (7.3%) patients who were initially admitted to either a general bay or to the TB cohorting bay AND were eventually transferred to the other one during hospitalization</a:t>
              </a:r>
              <a:endParaRPr lang="es-PE" sz="11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1559" y="4276130"/>
              <a:ext cx="1980221" cy="769441"/>
            </a:xfrm>
            <a:prstGeom prst="rect">
              <a:avLst/>
            </a:prstGeom>
            <a:solidFill>
              <a:srgbClr val="FFFF00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131 (12%) patients admitted directly to the TB cohorting bay and remained there until dead or discharge</a:t>
              </a:r>
              <a:endParaRPr lang="es-PE" sz="11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388799" y="4300914"/>
              <a:ext cx="2059429" cy="769441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883 (80.7%) patients were </a:t>
              </a:r>
              <a:r>
                <a:rPr lang="en-GB" sz="1100" b="1" dirty="0"/>
                <a:t>admitted directly to the general medicine bays and remained there until dead or discharge</a:t>
              </a:r>
            </a:p>
          </p:txBody>
        </p:sp>
        <p:cxnSp>
          <p:nvCxnSpPr>
            <p:cNvPr id="12" name="Elbow Connector 11"/>
            <p:cNvCxnSpPr>
              <a:stCxn id="5" idx="2"/>
              <a:endCxn id="11" idx="0"/>
            </p:cNvCxnSpPr>
            <p:nvPr/>
          </p:nvCxnSpPr>
          <p:spPr>
            <a:xfrm rot="16200000" flipH="1">
              <a:off x="4716556" y="1598955"/>
              <a:ext cx="857377" cy="4546539"/>
            </a:xfrm>
            <a:prstGeom prst="bentConnector3">
              <a:avLst>
                <a:gd name="adj1" fmla="val 69997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Elbow Connector 16"/>
            <p:cNvCxnSpPr>
              <a:stCxn id="5" idx="2"/>
              <a:endCxn id="9" idx="0"/>
            </p:cNvCxnSpPr>
            <p:nvPr/>
          </p:nvCxnSpPr>
          <p:spPr>
            <a:xfrm rot="16200000" flipH="1">
              <a:off x="3261593" y="3053918"/>
              <a:ext cx="843085" cy="1622321"/>
            </a:xfrm>
            <a:prstGeom prst="bentConnector3">
              <a:avLst>
                <a:gd name="adj1" fmla="val 72596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Elbow Connector 18"/>
            <p:cNvCxnSpPr>
              <a:stCxn id="5" idx="2"/>
              <a:endCxn id="10" idx="0"/>
            </p:cNvCxnSpPr>
            <p:nvPr/>
          </p:nvCxnSpPr>
          <p:spPr>
            <a:xfrm rot="5400000">
              <a:off x="1820527" y="3224681"/>
              <a:ext cx="832593" cy="1270305"/>
            </a:xfrm>
            <a:prstGeom prst="bentConnector3">
              <a:avLst>
                <a:gd name="adj1" fmla="val 7288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>
              <a:stCxn id="10" idx="2"/>
            </p:cNvCxnSpPr>
            <p:nvPr/>
          </p:nvCxnSpPr>
          <p:spPr>
            <a:xfrm flipH="1">
              <a:off x="1601669" y="5045571"/>
              <a:ext cx="1" cy="41870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>
              <a:stCxn id="9" idx="2"/>
            </p:cNvCxnSpPr>
            <p:nvPr/>
          </p:nvCxnSpPr>
          <p:spPr>
            <a:xfrm>
              <a:off x="4494296" y="5056063"/>
              <a:ext cx="0" cy="5124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>
              <a:stCxn id="11" idx="2"/>
            </p:cNvCxnSpPr>
            <p:nvPr/>
          </p:nvCxnSpPr>
          <p:spPr>
            <a:xfrm>
              <a:off x="7418514" y="5070355"/>
              <a:ext cx="1" cy="45258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51520" y="3600450"/>
              <a:ext cx="8196708" cy="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23528" y="864146"/>
              <a:ext cx="8124700" cy="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angle 31"/>
            <p:cNvSpPr/>
            <p:nvPr/>
          </p:nvSpPr>
          <p:spPr>
            <a:xfrm>
              <a:off x="323528" y="3658744"/>
              <a:ext cx="21113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b="1" u="sng" dirty="0"/>
                <a:t>During hospitalization:</a:t>
              </a:r>
              <a:endParaRPr lang="en-GB" sz="1600" b="1" u="sng" dirty="0"/>
            </a:p>
          </p:txBody>
        </p:sp>
        <p:sp>
          <p:nvSpPr>
            <p:cNvPr id="53" name="Oval 52"/>
            <p:cNvSpPr/>
            <p:nvPr/>
          </p:nvSpPr>
          <p:spPr>
            <a:xfrm>
              <a:off x="1669690" y="5112154"/>
              <a:ext cx="306035" cy="28803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 smtClean="0"/>
                <a:t>A</a:t>
              </a:r>
              <a:endParaRPr lang="es-PE" sz="2000" b="1" dirty="0"/>
            </a:p>
          </p:txBody>
        </p:sp>
        <p:sp>
          <p:nvSpPr>
            <p:cNvPr id="54" name="Oval 53"/>
            <p:cNvSpPr/>
            <p:nvPr/>
          </p:nvSpPr>
          <p:spPr>
            <a:xfrm>
              <a:off x="4572000" y="5112154"/>
              <a:ext cx="306035" cy="28803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 smtClean="0"/>
                <a:t>B</a:t>
              </a:r>
              <a:endParaRPr lang="es-PE" sz="2000" b="1" dirty="0"/>
            </a:p>
          </p:txBody>
        </p:sp>
        <p:sp>
          <p:nvSpPr>
            <p:cNvPr id="55" name="Oval 54"/>
            <p:cNvSpPr/>
            <p:nvPr/>
          </p:nvSpPr>
          <p:spPr>
            <a:xfrm>
              <a:off x="7524328" y="5112154"/>
              <a:ext cx="306035" cy="28803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/>
                <a:t>C</a:t>
              </a:r>
              <a:endParaRPr lang="es-PE" sz="2000" b="1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22201" y="360090"/>
              <a:ext cx="12974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 smtClean="0"/>
                <a:t>Figure 2.1.</a:t>
              </a:r>
              <a:endParaRPr lang="es-PE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010141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179512" y="216074"/>
            <a:ext cx="8712969" cy="6768752"/>
            <a:chOff x="179512" y="216074"/>
            <a:chExt cx="8712969" cy="6768752"/>
          </a:xfrm>
        </p:grpSpPr>
        <p:grpSp>
          <p:nvGrpSpPr>
            <p:cNvPr id="49" name="Group 48"/>
            <p:cNvGrpSpPr/>
            <p:nvPr/>
          </p:nvGrpSpPr>
          <p:grpSpPr>
            <a:xfrm>
              <a:off x="179512" y="648122"/>
              <a:ext cx="8712969" cy="6336704"/>
              <a:chOff x="179512" y="432098"/>
              <a:chExt cx="8712969" cy="6336704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4974367" y="3714521"/>
                <a:ext cx="1980221" cy="769441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3 (2.3%) patients were ruled out for active TB infection</a:t>
                </a:r>
                <a:endParaRPr lang="es-PE" sz="1100" b="1" dirty="0"/>
              </a:p>
              <a:p>
                <a:pPr algn="ctr"/>
                <a:endParaRPr lang="es-PE" sz="1100" b="1" dirty="0"/>
              </a:p>
              <a:p>
                <a:pPr algn="ctr"/>
                <a:endParaRPr lang="es-PE" sz="1100" b="1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76603" y="3714521"/>
                <a:ext cx="1980221" cy="600164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15 (87.8%) patients were confirmed to have TB microbiologically</a:t>
                </a:r>
                <a:endParaRPr lang="es-PE" sz="1100" b="1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796531" y="3714521"/>
                <a:ext cx="1831663" cy="769441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3 (9.9%) patients were diagnosed with TB based on clinical, radiographic or therapeutic grounds</a:t>
                </a:r>
                <a:endParaRPr lang="es-PE" sz="1100" b="1" dirty="0"/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470198" y="5040210"/>
                <a:ext cx="1986626" cy="1721525"/>
                <a:chOff x="-745827" y="5417133"/>
                <a:chExt cx="1422244" cy="1987335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>
                  <a:off x="-741241" y="5417133"/>
                  <a:ext cx="1417658" cy="888246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15 (13.1%) patients were diagnosed with new/relapse/recurrent TB during follow up</a:t>
                  </a:r>
                  <a:endParaRPr lang="es-PE" sz="1100" b="1" dirty="0"/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-745827" y="6516222"/>
                  <a:ext cx="1422244" cy="888246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10 (66.7%) patients died from confirmed or suspected TB (during follow up)</a:t>
                  </a:r>
                </a:p>
                <a:p>
                  <a:pPr algn="ctr"/>
                  <a:endParaRPr lang="es-PE" sz="1100" b="1" dirty="0"/>
                </a:p>
              </p:txBody>
            </p:sp>
            <p:cxnSp>
              <p:nvCxnSpPr>
                <p:cNvPr id="9" name="Straight Arrow Connector 8"/>
                <p:cNvCxnSpPr>
                  <a:stCxn id="7" idx="2"/>
                  <a:endCxn id="8" idx="0"/>
                </p:cNvCxnSpPr>
                <p:nvPr/>
              </p:nvCxnSpPr>
              <p:spPr>
                <a:xfrm flipH="1">
                  <a:off x="-34705" y="6305379"/>
                  <a:ext cx="2293" cy="210844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" name="Group 9"/>
              <p:cNvGrpSpPr/>
              <p:nvPr/>
            </p:nvGrpSpPr>
            <p:grpSpPr>
              <a:xfrm>
                <a:off x="2719049" y="5047278"/>
                <a:ext cx="1986626" cy="1721524"/>
                <a:chOff x="-745827" y="5417133"/>
                <a:chExt cx="1422244" cy="1987332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-741241" y="5417133"/>
                  <a:ext cx="1417658" cy="888245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4 (30.8%) </a:t>
                  </a:r>
                  <a:r>
                    <a:rPr lang="en-GB" sz="1100" b="1" dirty="0"/>
                    <a:t>patients were diagnosed with new/relapse/recurrent TB during follow up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-745827" y="6516220"/>
                  <a:ext cx="1422244" cy="888245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3 (75%) patients died from confirmed or suspected TB (during follow up)</a:t>
                  </a:r>
                </a:p>
                <a:p>
                  <a:pPr algn="ctr"/>
                  <a:endParaRPr lang="es-PE" sz="1100" b="1" dirty="0"/>
                </a:p>
              </p:txBody>
            </p:sp>
            <p:cxnSp>
              <p:nvCxnSpPr>
                <p:cNvPr id="13" name="Straight Arrow Connector 12"/>
                <p:cNvCxnSpPr>
                  <a:stCxn id="11" idx="2"/>
                  <a:endCxn id="12" idx="0"/>
                </p:cNvCxnSpPr>
                <p:nvPr/>
              </p:nvCxnSpPr>
              <p:spPr>
                <a:xfrm flipH="1">
                  <a:off x="-34705" y="6305378"/>
                  <a:ext cx="2293" cy="210842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" name="Group 13"/>
              <p:cNvGrpSpPr/>
              <p:nvPr/>
            </p:nvGrpSpPr>
            <p:grpSpPr>
              <a:xfrm>
                <a:off x="4967961" y="5033149"/>
                <a:ext cx="1986626" cy="1721524"/>
                <a:chOff x="-745827" y="5417133"/>
                <a:chExt cx="1422244" cy="1987332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>
                  <a:off x="-741241" y="5417133"/>
                  <a:ext cx="1417658" cy="888245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1 (33.3%) </a:t>
                  </a:r>
                  <a:r>
                    <a:rPr lang="en-GB" sz="1100" b="1" dirty="0"/>
                    <a:t>patient was diagnosed with new/relapse/recurrent TB during follow up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-745827" y="6516220"/>
                  <a:ext cx="1422244" cy="888245"/>
                </a:xfrm>
                <a:prstGeom prst="rect">
                  <a:avLst/>
                </a:prstGeom>
                <a:solidFill>
                  <a:srgbClr val="FFFF00"/>
                </a:solidFill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1100" b="1" dirty="0"/>
                    <a:t>No patient died from confirmed or suspected TB (during follow up)</a:t>
                  </a:r>
                </a:p>
                <a:p>
                  <a:pPr algn="ctr"/>
                  <a:endParaRPr lang="es-PE" sz="1100" b="1" dirty="0"/>
                </a:p>
              </p:txBody>
            </p:sp>
            <p:cxnSp>
              <p:nvCxnSpPr>
                <p:cNvPr id="17" name="Straight Arrow Connector 16"/>
                <p:cNvCxnSpPr>
                  <a:stCxn id="15" idx="2"/>
                  <a:endCxn id="16" idx="0"/>
                </p:cNvCxnSpPr>
                <p:nvPr/>
              </p:nvCxnSpPr>
              <p:spPr>
                <a:xfrm flipH="1">
                  <a:off x="-34705" y="6305378"/>
                  <a:ext cx="2293" cy="210842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" name="Elbow Connector 17"/>
              <p:cNvCxnSpPr>
                <a:stCxn id="26" idx="2"/>
                <a:endCxn id="4" idx="0"/>
              </p:cNvCxnSpPr>
              <p:nvPr/>
            </p:nvCxnSpPr>
            <p:spPr>
              <a:xfrm rot="5400000">
                <a:off x="1310284" y="2978138"/>
                <a:ext cx="892814" cy="579953"/>
              </a:xfrm>
              <a:prstGeom prst="bent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Elbow Connector 18"/>
              <p:cNvCxnSpPr>
                <a:stCxn id="26" idx="2"/>
                <a:endCxn id="5" idx="0"/>
              </p:cNvCxnSpPr>
              <p:nvPr/>
            </p:nvCxnSpPr>
            <p:spPr>
              <a:xfrm rot="16200000" flipH="1">
                <a:off x="2433108" y="2435266"/>
                <a:ext cx="892814" cy="1665696"/>
              </a:xfrm>
              <a:prstGeom prst="bent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/>
              <p:cNvCxnSpPr>
                <a:stCxn id="5" idx="2"/>
                <a:endCxn id="11" idx="0"/>
              </p:cNvCxnSpPr>
              <p:nvPr/>
            </p:nvCxnSpPr>
            <p:spPr>
              <a:xfrm>
                <a:off x="3712363" y="4483962"/>
                <a:ext cx="3202" cy="56331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>
                <a:stCxn id="4" idx="2"/>
                <a:endCxn id="7" idx="0"/>
              </p:cNvCxnSpPr>
              <p:nvPr/>
            </p:nvCxnSpPr>
            <p:spPr>
              <a:xfrm>
                <a:off x="1466714" y="4314685"/>
                <a:ext cx="0" cy="72552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/>
              <p:cNvCxnSpPr>
                <a:stCxn id="3" idx="2"/>
                <a:endCxn id="15" idx="0"/>
              </p:cNvCxnSpPr>
              <p:nvPr/>
            </p:nvCxnSpPr>
            <p:spPr>
              <a:xfrm flipH="1">
                <a:off x="5964477" y="4483962"/>
                <a:ext cx="1" cy="54918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476603" y="434420"/>
                <a:ext cx="7907362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u="sng" dirty="0"/>
                  <a:t>During hospitalization:</a:t>
                </a:r>
              </a:p>
              <a:p>
                <a:r>
                  <a:rPr lang="en-GB" sz="1200" b="1" dirty="0"/>
                  <a:t>12 (5.6%) of the 215 patients who were diagnosed with TB during their admission died before discharge.  Considering that 178 (16.3%) of the 1,094 inpatients died before discharge, 6.7% (12 of 178) of the inpatient period mortality was attributable to TB.  14 (7.9%) additional patients died with pneumonia of undetermined aetiology. 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212604" y="2072829"/>
                <a:ext cx="3089144" cy="769441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0 (7.3%) patients who were initially admitted to either a general bay or to the TB cohorting bay AND were eventually transferred to the other one during hospitalization</a:t>
                </a:r>
                <a:endParaRPr lang="es-PE" sz="11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056556" y="2052266"/>
                <a:ext cx="1980221" cy="769441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31 (12%) patients admitted directly to the TB cohorting bay and remained there until dead or discharge</a:t>
                </a:r>
                <a:endParaRPr lang="es-PE" sz="11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513398" y="2077050"/>
                <a:ext cx="1870567" cy="938719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83 (80.7%) patients were </a:t>
                </a:r>
                <a:r>
                  <a:rPr lang="en-GB" sz="1100" b="1" dirty="0"/>
                  <a:t>admitted directly to the general medicine bays and remained there until dead or discharge</a:t>
                </a:r>
              </a:p>
            </p:txBody>
          </p:sp>
          <p:cxnSp>
            <p:nvCxnSpPr>
              <p:cNvPr id="28" name="Elbow Connector 27"/>
              <p:cNvCxnSpPr>
                <a:endCxn id="27" idx="0"/>
              </p:cNvCxnSpPr>
              <p:nvPr/>
            </p:nvCxnSpPr>
            <p:spPr>
              <a:xfrm>
                <a:off x="3316973" y="1659012"/>
                <a:ext cx="4131709" cy="418038"/>
              </a:xfrm>
              <a:prstGeom prst="bentConnector2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Elbow Connector 29"/>
              <p:cNvCxnSpPr>
                <a:endCxn id="26" idx="0"/>
              </p:cNvCxnSpPr>
              <p:nvPr/>
            </p:nvCxnSpPr>
            <p:spPr>
              <a:xfrm rot="5400000">
                <a:off x="2297336" y="1032629"/>
                <a:ext cx="768969" cy="1270305"/>
              </a:xfrm>
              <a:prstGeom prst="bentConnector3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Elbow Connector 32"/>
              <p:cNvCxnSpPr>
                <a:stCxn id="26" idx="2"/>
                <a:endCxn id="3" idx="0"/>
              </p:cNvCxnSpPr>
              <p:nvPr/>
            </p:nvCxnSpPr>
            <p:spPr>
              <a:xfrm rot="16200000" flipH="1">
                <a:off x="3559165" y="1309208"/>
                <a:ext cx="892814" cy="3917811"/>
              </a:xfrm>
              <a:prstGeom prst="bent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>
                <a:endCxn id="25" idx="0"/>
              </p:cNvCxnSpPr>
              <p:nvPr/>
            </p:nvCxnSpPr>
            <p:spPr>
              <a:xfrm>
                <a:off x="4757176" y="1659012"/>
                <a:ext cx="0" cy="41381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179512" y="4680570"/>
                <a:ext cx="8712969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179512" y="432098"/>
                <a:ext cx="8712969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7236295" y="4911690"/>
                <a:ext cx="1656185" cy="17851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u="sng" dirty="0"/>
                  <a:t>During follow-up: </a:t>
                </a:r>
                <a:r>
                  <a:rPr lang="en-GB" sz="1200" b="1" dirty="0"/>
                  <a:t>Of the 916 patients  who were eventually discharged for the Medical Wards, 51 (5.6%) developed TB during the  first year of follow up.  Of them 26 (51%) died.</a:t>
                </a:r>
              </a:p>
            </p:txBody>
          </p:sp>
          <p:sp>
            <p:nvSpPr>
              <p:cNvPr id="48" name="Oval 47"/>
              <p:cNvSpPr/>
              <p:nvPr/>
            </p:nvSpPr>
            <p:spPr>
              <a:xfrm>
                <a:off x="1669224" y="2875799"/>
                <a:ext cx="306035" cy="28803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2000" b="1" dirty="0" smtClean="0"/>
                  <a:t>A</a:t>
                </a:r>
                <a:endParaRPr lang="es-PE" sz="2000" b="1" dirty="0"/>
              </a:p>
            </p:txBody>
          </p:sp>
        </p:grpSp>
        <p:sp>
          <p:nvSpPr>
            <p:cNvPr id="50" name="TextBox 49"/>
            <p:cNvSpPr txBox="1"/>
            <p:nvPr/>
          </p:nvSpPr>
          <p:spPr>
            <a:xfrm>
              <a:off x="322201" y="216074"/>
              <a:ext cx="12974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 smtClean="0"/>
                <a:t>Figure 2.2.</a:t>
              </a:r>
              <a:endParaRPr lang="es-PE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4308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144016" y="360090"/>
            <a:ext cx="8783960" cy="6411961"/>
            <a:chOff x="144016" y="360090"/>
            <a:chExt cx="8783960" cy="6411961"/>
          </a:xfrm>
        </p:grpSpPr>
        <p:grpSp>
          <p:nvGrpSpPr>
            <p:cNvPr id="8" name="Group 7"/>
            <p:cNvGrpSpPr/>
            <p:nvPr/>
          </p:nvGrpSpPr>
          <p:grpSpPr>
            <a:xfrm>
              <a:off x="937692" y="1626197"/>
              <a:ext cx="7327409" cy="1732472"/>
              <a:chOff x="1056556" y="1283297"/>
              <a:chExt cx="7327409" cy="1732472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3212604" y="2072829"/>
                <a:ext cx="3089144" cy="769441"/>
              </a:xfrm>
              <a:prstGeom prst="rect">
                <a:avLst/>
              </a:prstGeom>
              <a:solidFill>
                <a:schemeClr val="accent1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0 (7.3%) patients who were initially admitted to either a general bay or to the TB cohorting bay AND were eventually transferred to the other one during hospitalization</a:t>
                </a:r>
                <a:endParaRPr lang="es-PE" sz="1100" b="1" dirty="0"/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1056556" y="2052266"/>
                <a:ext cx="1980221" cy="769441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31 (12%) patients admitted directly to the TB cohorting bay and remained there until dead or discharge</a:t>
                </a:r>
                <a:endParaRPr lang="es-PE" sz="1100" b="1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6513398" y="2077050"/>
                <a:ext cx="1870567" cy="938719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83 (80.7%) patients were </a:t>
                </a:r>
                <a:r>
                  <a:rPr lang="en-GB" sz="1100" b="1" dirty="0"/>
                  <a:t>admitted directly to the general medicine bays and remained there until dead or discharge</a:t>
                </a:r>
              </a:p>
            </p:txBody>
          </p:sp>
          <p:cxnSp>
            <p:nvCxnSpPr>
              <p:cNvPr id="5" name="Elbow Connector 4"/>
              <p:cNvCxnSpPr>
                <a:endCxn id="4" idx="0"/>
              </p:cNvCxnSpPr>
              <p:nvPr/>
            </p:nvCxnSpPr>
            <p:spPr>
              <a:xfrm>
                <a:off x="3316973" y="1659012"/>
                <a:ext cx="4131709" cy="418038"/>
              </a:xfrm>
              <a:prstGeom prst="bentConnector2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Elbow Connector 5"/>
              <p:cNvCxnSpPr>
                <a:endCxn id="3" idx="0"/>
              </p:cNvCxnSpPr>
              <p:nvPr/>
            </p:nvCxnSpPr>
            <p:spPr>
              <a:xfrm rot="5400000">
                <a:off x="2297336" y="1032629"/>
                <a:ext cx="768969" cy="1270305"/>
              </a:xfrm>
              <a:prstGeom prst="bentConnector3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Arrow Connector 6"/>
              <p:cNvCxnSpPr>
                <a:endCxn id="2" idx="0"/>
              </p:cNvCxnSpPr>
              <p:nvPr/>
            </p:nvCxnSpPr>
            <p:spPr>
              <a:xfrm>
                <a:off x="4757176" y="1659012"/>
                <a:ext cx="0" cy="41381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TextBox 9"/>
            <p:cNvSpPr txBox="1"/>
            <p:nvPr/>
          </p:nvSpPr>
          <p:spPr>
            <a:xfrm>
              <a:off x="6004559" y="3745745"/>
              <a:ext cx="1656485" cy="769441"/>
            </a:xfrm>
            <a:prstGeom prst="rect">
              <a:avLst/>
            </a:prstGeom>
            <a:solidFill>
              <a:schemeClr val="accent1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3 (3.8%) </a:t>
              </a:r>
              <a:r>
                <a:rPr lang="en-GB" sz="1100" b="1" dirty="0"/>
                <a:t>patients were ruled out for active TB infection</a:t>
              </a:r>
            </a:p>
            <a:p>
              <a:pPr algn="ctr"/>
              <a:endParaRPr lang="es-PE" sz="11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05814" y="3761996"/>
              <a:ext cx="1824701" cy="769441"/>
            </a:xfrm>
            <a:prstGeom prst="rect">
              <a:avLst/>
            </a:prstGeom>
            <a:solidFill>
              <a:schemeClr val="accent1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70 (87.5%) </a:t>
              </a:r>
              <a:r>
                <a:rPr lang="en-GB" sz="1100" b="1" dirty="0"/>
                <a:t>patients were confirmed to have TB microbiologically</a:t>
              </a:r>
            </a:p>
            <a:p>
              <a:pPr algn="ctr"/>
              <a:endParaRPr lang="es-PE" sz="11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718632" y="3761996"/>
              <a:ext cx="1831663" cy="769441"/>
            </a:xfrm>
            <a:prstGeom prst="rect">
              <a:avLst/>
            </a:prstGeom>
            <a:solidFill>
              <a:schemeClr val="accent1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7 (8.8%) </a:t>
              </a:r>
              <a:r>
                <a:rPr lang="en-GB" sz="1100" b="1" dirty="0"/>
                <a:t>patients were diagnosed with TB based on clinical, radiographic or therapeutic grounds</a:t>
              </a:r>
              <a:endParaRPr lang="es-PE" sz="1100" b="1" dirty="0"/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405232" y="5050527"/>
              <a:ext cx="1986626" cy="1721524"/>
              <a:chOff x="-745827" y="5417133"/>
              <a:chExt cx="1422244" cy="1987332"/>
            </a:xfrm>
            <a:solidFill>
              <a:schemeClr val="accent1"/>
            </a:solidFill>
          </p:grpSpPr>
          <p:sp>
            <p:nvSpPr>
              <p:cNvPr id="14" name="TextBox 13"/>
              <p:cNvSpPr txBox="1"/>
              <p:nvPr/>
            </p:nvSpPr>
            <p:spPr>
              <a:xfrm>
                <a:off x="-741241" y="5417133"/>
                <a:ext cx="1417658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0 (14.3%) </a:t>
                </a:r>
                <a:r>
                  <a:rPr lang="en-GB" sz="1100" b="1" dirty="0"/>
                  <a:t>patient was diagnosed with new/relapse/recurrent TB during follow up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-745827" y="6516220"/>
                <a:ext cx="1422244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6 (60%) patients died from confirmed or suspected TB (during follow up)</a:t>
                </a:r>
              </a:p>
              <a:p>
                <a:pPr algn="ctr"/>
                <a:endParaRPr lang="es-PE" sz="1100" b="1" dirty="0"/>
              </a:p>
            </p:txBody>
          </p:sp>
          <p:cxnSp>
            <p:nvCxnSpPr>
              <p:cNvPr id="16" name="Straight Arrow Connector 15"/>
              <p:cNvCxnSpPr>
                <a:stCxn id="14" idx="2"/>
                <a:endCxn id="15" idx="0"/>
              </p:cNvCxnSpPr>
              <p:nvPr/>
            </p:nvCxnSpPr>
            <p:spPr>
              <a:xfrm flipH="1">
                <a:off x="-34705" y="6305378"/>
                <a:ext cx="2293" cy="210842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 16"/>
            <p:cNvGrpSpPr/>
            <p:nvPr/>
          </p:nvGrpSpPr>
          <p:grpSpPr>
            <a:xfrm>
              <a:off x="5837532" y="5050242"/>
              <a:ext cx="1986626" cy="1721524"/>
              <a:chOff x="-745827" y="5417133"/>
              <a:chExt cx="1422244" cy="1987332"/>
            </a:xfrm>
            <a:solidFill>
              <a:schemeClr val="accent1"/>
            </a:solidFill>
          </p:grpSpPr>
          <p:sp>
            <p:nvSpPr>
              <p:cNvPr id="18" name="TextBox 17"/>
              <p:cNvSpPr txBox="1"/>
              <p:nvPr/>
            </p:nvSpPr>
            <p:spPr>
              <a:xfrm>
                <a:off x="-741241" y="5417133"/>
                <a:ext cx="1417658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 (33.3%) </a:t>
                </a:r>
                <a:r>
                  <a:rPr lang="en-GB" sz="1100" b="1" dirty="0"/>
                  <a:t>patient was diagnosed with new/relapse/recurrent TB during follow up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-745827" y="6516220"/>
                <a:ext cx="1422244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No patients died from confirmed or suspected TB (during follow up)</a:t>
                </a:r>
              </a:p>
              <a:p>
                <a:pPr algn="ctr"/>
                <a:endParaRPr lang="es-PE" sz="1100" b="1" dirty="0"/>
              </a:p>
            </p:txBody>
          </p:sp>
          <p:cxnSp>
            <p:nvCxnSpPr>
              <p:cNvPr id="20" name="Straight Arrow Connector 19"/>
              <p:cNvCxnSpPr>
                <a:stCxn id="18" idx="2"/>
                <a:endCxn id="19" idx="0"/>
              </p:cNvCxnSpPr>
              <p:nvPr/>
            </p:nvCxnSpPr>
            <p:spPr>
              <a:xfrm flipH="1">
                <a:off x="-34705" y="6305378"/>
                <a:ext cx="2293" cy="210842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" name="Elbow Connector 20"/>
            <p:cNvCxnSpPr>
              <a:stCxn id="2" idx="2"/>
              <a:endCxn id="11" idx="0"/>
            </p:cNvCxnSpPr>
            <p:nvPr/>
          </p:nvCxnSpPr>
          <p:spPr>
            <a:xfrm rot="5400000">
              <a:off x="3239826" y="2363510"/>
              <a:ext cx="576826" cy="2220147"/>
            </a:xfrm>
            <a:prstGeom prst="bentConnector3">
              <a:avLst>
                <a:gd name="adj1" fmla="val 5000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Group 21"/>
            <p:cNvGrpSpPr/>
            <p:nvPr/>
          </p:nvGrpSpPr>
          <p:grpSpPr>
            <a:xfrm>
              <a:off x="3635788" y="5050529"/>
              <a:ext cx="1986626" cy="1552243"/>
              <a:chOff x="-745827" y="5417133"/>
              <a:chExt cx="1422244" cy="1791913"/>
            </a:xfrm>
            <a:solidFill>
              <a:schemeClr val="accent1"/>
            </a:solidFill>
          </p:grpSpPr>
          <p:sp>
            <p:nvSpPr>
              <p:cNvPr id="23" name="TextBox 22"/>
              <p:cNvSpPr txBox="1"/>
              <p:nvPr/>
            </p:nvSpPr>
            <p:spPr>
              <a:xfrm>
                <a:off x="-741241" y="5417133"/>
                <a:ext cx="1417658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 (14.3%) </a:t>
                </a:r>
                <a:r>
                  <a:rPr lang="en-GB" sz="1100" b="1" dirty="0"/>
                  <a:t>patient was diagnosed with new/relapse/recurrent TB during follow up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-745827" y="6516215"/>
                <a:ext cx="1422244" cy="692831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/>
                  <a:t>No patients died from confirmed or suspected TB (during follow up</a:t>
                </a:r>
                <a:endParaRPr lang="es-PE" sz="1100" b="1" dirty="0"/>
              </a:p>
            </p:txBody>
          </p:sp>
          <p:cxnSp>
            <p:nvCxnSpPr>
              <p:cNvPr id="25" name="Straight Arrow Connector 24"/>
              <p:cNvCxnSpPr>
                <a:stCxn id="23" idx="2"/>
                <a:endCxn id="24" idx="0"/>
              </p:cNvCxnSpPr>
              <p:nvPr/>
            </p:nvCxnSpPr>
            <p:spPr>
              <a:xfrm flipH="1">
                <a:off x="-34705" y="6305378"/>
                <a:ext cx="2293" cy="210838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" name="Elbow Connector 25"/>
            <p:cNvCxnSpPr>
              <a:stCxn id="2" idx="2"/>
              <a:endCxn id="10" idx="0"/>
            </p:cNvCxnSpPr>
            <p:nvPr/>
          </p:nvCxnSpPr>
          <p:spPr>
            <a:xfrm rot="16200000" flipH="1">
              <a:off x="5455270" y="2368212"/>
              <a:ext cx="560575" cy="2194490"/>
            </a:xfrm>
            <a:prstGeom prst="bentConnector3">
              <a:avLst>
                <a:gd name="adj1" fmla="val 5000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>
              <a:stCxn id="2" idx="2"/>
              <a:endCxn id="12" idx="0"/>
            </p:cNvCxnSpPr>
            <p:nvPr/>
          </p:nvCxnSpPr>
          <p:spPr>
            <a:xfrm flipH="1">
              <a:off x="4634464" y="3185170"/>
              <a:ext cx="3848" cy="57682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>
              <a:stCxn id="12" idx="2"/>
              <a:endCxn id="23" idx="0"/>
            </p:cNvCxnSpPr>
            <p:nvPr/>
          </p:nvCxnSpPr>
          <p:spPr>
            <a:xfrm flipH="1">
              <a:off x="4632304" y="4531437"/>
              <a:ext cx="2160" cy="51909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>
              <a:stCxn id="11" idx="2"/>
              <a:endCxn id="14" idx="0"/>
            </p:cNvCxnSpPr>
            <p:nvPr/>
          </p:nvCxnSpPr>
          <p:spPr>
            <a:xfrm flipH="1">
              <a:off x="2401748" y="4531437"/>
              <a:ext cx="16418" cy="51909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144016" y="4782714"/>
              <a:ext cx="8748464" cy="827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>
              <a:stCxn id="10" idx="2"/>
              <a:endCxn id="18" idx="0"/>
            </p:cNvCxnSpPr>
            <p:nvPr/>
          </p:nvCxnSpPr>
          <p:spPr>
            <a:xfrm>
              <a:off x="6832802" y="4515186"/>
              <a:ext cx="1246" cy="5350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79512" y="1008162"/>
              <a:ext cx="8748464" cy="827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>
              <a:off x="323528" y="1152178"/>
              <a:ext cx="21113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b="1" u="sng" dirty="0"/>
                <a:t>During hospitalization:</a:t>
              </a:r>
              <a:endParaRPr lang="en-GB" sz="1600" b="1" u="sng" dirty="0"/>
            </a:p>
          </p:txBody>
        </p:sp>
        <p:sp>
          <p:nvSpPr>
            <p:cNvPr id="45" name="Oval 44"/>
            <p:cNvSpPr/>
            <p:nvPr/>
          </p:nvSpPr>
          <p:spPr>
            <a:xfrm>
              <a:off x="4672001" y="2064804"/>
              <a:ext cx="306035" cy="28803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/>
                <a:t>B</a:t>
              </a:r>
              <a:endParaRPr lang="es-PE" sz="20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22201" y="360090"/>
              <a:ext cx="12974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 smtClean="0"/>
                <a:t>Figure 2.3.</a:t>
              </a:r>
              <a:endParaRPr lang="es-PE" sz="2000" b="1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323528" y="4959891"/>
              <a:ext cx="1081704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b="1" u="sng" dirty="0"/>
                <a:t>During </a:t>
              </a:r>
              <a:r>
                <a:rPr lang="en-GB" sz="1600" b="1" u="sng" dirty="0" smtClean="0"/>
                <a:t>follow-up</a:t>
              </a:r>
              <a:endParaRPr lang="en-GB" sz="1600" b="1" u="sng" dirty="0"/>
            </a:p>
          </p:txBody>
        </p:sp>
      </p:grpSp>
    </p:spTree>
    <p:extLst>
      <p:ext uri="{BB962C8B-B14F-4D97-AF65-F5344CB8AC3E}">
        <p14:creationId xmlns:p14="http://schemas.microsoft.com/office/powerpoint/2010/main" val="4065668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/>
          <p:cNvGrpSpPr/>
          <p:nvPr/>
        </p:nvGrpSpPr>
        <p:grpSpPr>
          <a:xfrm>
            <a:off x="179512" y="248012"/>
            <a:ext cx="8820472" cy="6304766"/>
            <a:chOff x="179512" y="248012"/>
            <a:chExt cx="8820472" cy="6304766"/>
          </a:xfrm>
        </p:grpSpPr>
        <p:sp>
          <p:nvSpPr>
            <p:cNvPr id="2" name="Rectangle 1"/>
            <p:cNvSpPr/>
            <p:nvPr/>
          </p:nvSpPr>
          <p:spPr>
            <a:xfrm>
              <a:off x="323528" y="792138"/>
              <a:ext cx="211134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b="1" u="sng" dirty="0"/>
                <a:t>During hospitalization:</a:t>
              </a:r>
              <a:endParaRPr lang="en-GB" sz="1600" b="1" u="sng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682387" y="3458615"/>
              <a:ext cx="1994069" cy="600164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873 (98.8%) never presented clinical evidence of TB or were ruled out for TB infection</a:t>
              </a:r>
              <a:endParaRPr lang="es-PE" sz="11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188483" y="3458615"/>
              <a:ext cx="1986626" cy="430887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6 (0.7%) patients had a microbiological diagnosis of TB</a:t>
              </a:r>
              <a:endParaRPr lang="es-PE" sz="11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447096" y="3458615"/>
              <a:ext cx="1977271" cy="769441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1100" b="1" dirty="0"/>
                <a:t> 4 (0.5) patients were clinically diagnosed with TB and started on treatment</a:t>
              </a:r>
            </a:p>
            <a:p>
              <a:pPr algn="ctr"/>
              <a:endParaRPr lang="es-PE" sz="1100" b="1" dirty="0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2187310" y="4831254"/>
              <a:ext cx="1986626" cy="1721524"/>
              <a:chOff x="-745827" y="5417133"/>
              <a:chExt cx="1422244" cy="1987332"/>
            </a:xfrm>
            <a:solidFill>
              <a:schemeClr val="accent2">
                <a:lumMod val="75000"/>
              </a:schemeClr>
            </a:solidFill>
          </p:grpSpPr>
          <p:sp>
            <p:nvSpPr>
              <p:cNvPr id="7" name="TextBox 6"/>
              <p:cNvSpPr txBox="1"/>
              <p:nvPr/>
            </p:nvSpPr>
            <p:spPr>
              <a:xfrm>
                <a:off x="-741241" y="5417133"/>
                <a:ext cx="1417658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2 (33.3%)</a:t>
                </a:r>
                <a:r>
                  <a:rPr lang="en-GB" sz="1100" b="1" dirty="0"/>
                  <a:t> patient was diagnosed with new/relapse/recurrent TB during follow up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-745827" y="6516220"/>
                <a:ext cx="1422244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 (50%) patient died from confirmed or suspected TB (during follow up)</a:t>
                </a:r>
              </a:p>
              <a:p>
                <a:pPr algn="ctr"/>
                <a:endParaRPr lang="es-PE" sz="1100" b="1" dirty="0"/>
              </a:p>
            </p:txBody>
          </p:sp>
          <p:cxnSp>
            <p:nvCxnSpPr>
              <p:cNvPr id="9" name="Straight Arrow Connector 8"/>
              <p:cNvCxnSpPr>
                <a:stCxn id="7" idx="2"/>
                <a:endCxn id="8" idx="0"/>
              </p:cNvCxnSpPr>
              <p:nvPr/>
            </p:nvCxnSpPr>
            <p:spPr>
              <a:xfrm flipH="1">
                <a:off x="-34705" y="6305378"/>
                <a:ext cx="2293" cy="210842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/>
            <p:cNvGrpSpPr/>
            <p:nvPr/>
          </p:nvGrpSpPr>
          <p:grpSpPr>
            <a:xfrm>
              <a:off x="4436162" y="4838322"/>
              <a:ext cx="1986626" cy="1552243"/>
              <a:chOff x="-745827" y="5417133"/>
              <a:chExt cx="1422244" cy="1791913"/>
            </a:xfrm>
            <a:solidFill>
              <a:schemeClr val="accent2">
                <a:lumMod val="75000"/>
              </a:schemeClr>
            </a:solidFill>
          </p:grpSpPr>
          <p:sp>
            <p:nvSpPr>
              <p:cNvPr id="11" name="TextBox 10"/>
              <p:cNvSpPr txBox="1"/>
              <p:nvPr/>
            </p:nvSpPr>
            <p:spPr>
              <a:xfrm>
                <a:off x="-741241" y="5417133"/>
                <a:ext cx="1417658" cy="888245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 1 (25%)</a:t>
                </a:r>
                <a:r>
                  <a:rPr lang="en-GB" sz="1100" b="1" dirty="0"/>
                  <a:t> patient was diagnosed with new/relapse/recurrent TB during follow up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-745827" y="6516215"/>
                <a:ext cx="1422244" cy="692831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/>
                  <a:t>No patients died from confirmed or suspected TB (during follow up)</a:t>
                </a:r>
              </a:p>
            </p:txBody>
          </p:sp>
          <p:cxnSp>
            <p:nvCxnSpPr>
              <p:cNvPr id="13" name="Straight Arrow Connector 12"/>
              <p:cNvCxnSpPr>
                <a:stCxn id="11" idx="2"/>
                <a:endCxn id="12" idx="0"/>
              </p:cNvCxnSpPr>
              <p:nvPr/>
            </p:nvCxnSpPr>
            <p:spPr>
              <a:xfrm flipH="1">
                <a:off x="-34705" y="6305378"/>
                <a:ext cx="2293" cy="210838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/>
            <p:cNvGrpSpPr/>
            <p:nvPr/>
          </p:nvGrpSpPr>
          <p:grpSpPr>
            <a:xfrm>
              <a:off x="6685075" y="4824188"/>
              <a:ext cx="1986626" cy="1721525"/>
              <a:chOff x="-745827" y="5417133"/>
              <a:chExt cx="1422244" cy="1987335"/>
            </a:xfrm>
            <a:solidFill>
              <a:schemeClr val="accent2">
                <a:lumMod val="75000"/>
              </a:schemeClr>
            </a:solidFill>
          </p:grpSpPr>
          <p:sp>
            <p:nvSpPr>
              <p:cNvPr id="15" name="TextBox 14"/>
              <p:cNvSpPr txBox="1"/>
              <p:nvPr/>
            </p:nvSpPr>
            <p:spPr>
              <a:xfrm>
                <a:off x="-741241" y="5417133"/>
                <a:ext cx="1417658" cy="888246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 16 (18.3%) </a:t>
                </a:r>
                <a:r>
                  <a:rPr lang="en-GB" sz="1100" b="1" dirty="0"/>
                  <a:t>patient was diagnosed with new/relapse/recurrent TB during follow up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-745827" y="6516222"/>
                <a:ext cx="1422244" cy="888246"/>
              </a:xfrm>
              <a:prstGeom prst="rect">
                <a:avLst/>
              </a:prstGeom>
              <a:grp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6 (37.5%) patients died from confirmed or suspected TB (during follow up)</a:t>
                </a:r>
              </a:p>
              <a:p>
                <a:pPr algn="ctr"/>
                <a:endParaRPr lang="es-PE" sz="1100" b="1" dirty="0"/>
              </a:p>
            </p:txBody>
          </p:sp>
          <p:cxnSp>
            <p:nvCxnSpPr>
              <p:cNvPr id="17" name="Straight Arrow Connector 16"/>
              <p:cNvCxnSpPr>
                <a:stCxn id="15" idx="2"/>
                <a:endCxn id="16" idx="0"/>
              </p:cNvCxnSpPr>
              <p:nvPr/>
            </p:nvCxnSpPr>
            <p:spPr>
              <a:xfrm flipH="1">
                <a:off x="-34705" y="6305379"/>
                <a:ext cx="2293" cy="210844"/>
              </a:xfrm>
              <a:prstGeom prst="straightConnector1">
                <a:avLst/>
              </a:prstGeom>
              <a:grpFill/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" name="Straight Arrow Connector 17"/>
            <p:cNvCxnSpPr>
              <a:stCxn id="5" idx="2"/>
              <a:endCxn id="11" idx="0"/>
            </p:cNvCxnSpPr>
            <p:nvPr/>
          </p:nvCxnSpPr>
          <p:spPr>
            <a:xfrm flipH="1">
              <a:off x="5432678" y="4228056"/>
              <a:ext cx="3054" cy="61026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>
              <a:stCxn id="4" idx="2"/>
              <a:endCxn id="7" idx="0"/>
            </p:cNvCxnSpPr>
            <p:nvPr/>
          </p:nvCxnSpPr>
          <p:spPr>
            <a:xfrm>
              <a:off x="3181796" y="3889502"/>
              <a:ext cx="2030" cy="94175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>
              <a:stCxn id="3" idx="2"/>
              <a:endCxn id="15" idx="0"/>
            </p:cNvCxnSpPr>
            <p:nvPr/>
          </p:nvCxnSpPr>
          <p:spPr>
            <a:xfrm>
              <a:off x="7679422" y="4058779"/>
              <a:ext cx="2169" cy="76540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20"/>
            <p:cNvGrpSpPr/>
            <p:nvPr/>
          </p:nvGrpSpPr>
          <p:grpSpPr>
            <a:xfrm>
              <a:off x="395536" y="1224186"/>
              <a:ext cx="7327409" cy="1732472"/>
              <a:chOff x="1056556" y="1283297"/>
              <a:chExt cx="7327409" cy="1732472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3212604" y="2072829"/>
                <a:ext cx="3089144" cy="769441"/>
              </a:xfrm>
              <a:prstGeom prst="rect">
                <a:avLst/>
              </a:prstGeom>
              <a:solidFill>
                <a:schemeClr val="accent1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0 (7.3%) patients who were initially admitted to either a general bay or to the TB cohorting bay AND were eventually transferred to the other one during hospitalization</a:t>
                </a:r>
                <a:endParaRPr lang="es-PE" sz="11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056556" y="2052266"/>
                <a:ext cx="1980221" cy="769441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131 (12%) patients admitted directly to the TB cohorting bay and remained there until dead or discharge</a:t>
                </a:r>
                <a:endParaRPr lang="es-PE" sz="11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513398" y="2077050"/>
                <a:ext cx="1870567" cy="938719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1100" b="1" dirty="0"/>
                  <a:t>883 (80.7%) patients were </a:t>
                </a:r>
                <a:r>
                  <a:rPr lang="en-GB" sz="1100" b="1" dirty="0"/>
                  <a:t>admitted directly to the general medicine bays and remained there until dead or discharge</a:t>
                </a:r>
              </a:p>
            </p:txBody>
          </p:sp>
          <p:cxnSp>
            <p:nvCxnSpPr>
              <p:cNvPr id="25" name="Elbow Connector 24"/>
              <p:cNvCxnSpPr>
                <a:endCxn id="24" idx="0"/>
              </p:cNvCxnSpPr>
              <p:nvPr/>
            </p:nvCxnSpPr>
            <p:spPr>
              <a:xfrm>
                <a:off x="3316973" y="1659012"/>
                <a:ext cx="4131709" cy="418038"/>
              </a:xfrm>
              <a:prstGeom prst="bentConnector2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Elbow Connector 25"/>
              <p:cNvCxnSpPr>
                <a:endCxn id="23" idx="0"/>
              </p:cNvCxnSpPr>
              <p:nvPr/>
            </p:nvCxnSpPr>
            <p:spPr>
              <a:xfrm rot="5400000">
                <a:off x="2297336" y="1032629"/>
                <a:ext cx="768969" cy="1270305"/>
              </a:xfrm>
              <a:prstGeom prst="bentConnector3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/>
              <p:cNvCxnSpPr>
                <a:endCxn id="22" idx="0"/>
              </p:cNvCxnSpPr>
              <p:nvPr/>
            </p:nvCxnSpPr>
            <p:spPr>
              <a:xfrm>
                <a:off x="4757176" y="1659012"/>
                <a:ext cx="0" cy="41381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" name="Elbow Connector 28"/>
            <p:cNvCxnSpPr>
              <a:stCxn id="24" idx="2"/>
              <a:endCxn id="4" idx="0"/>
            </p:cNvCxnSpPr>
            <p:nvPr/>
          </p:nvCxnSpPr>
          <p:spPr>
            <a:xfrm rot="5400000">
              <a:off x="4733751" y="1404703"/>
              <a:ext cx="501957" cy="3605866"/>
            </a:xfrm>
            <a:prstGeom prst="bentConnector3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Elbow Connector 30"/>
            <p:cNvCxnSpPr>
              <a:stCxn id="24" idx="2"/>
              <a:endCxn id="5" idx="0"/>
            </p:cNvCxnSpPr>
            <p:nvPr/>
          </p:nvCxnSpPr>
          <p:spPr>
            <a:xfrm rot="5400000">
              <a:off x="5860719" y="2531671"/>
              <a:ext cx="501957" cy="1351930"/>
            </a:xfrm>
            <a:prstGeom prst="bentConnector3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Elbow Connector 32"/>
            <p:cNvCxnSpPr>
              <a:stCxn id="24" idx="2"/>
              <a:endCxn id="3" idx="0"/>
            </p:cNvCxnSpPr>
            <p:nvPr/>
          </p:nvCxnSpPr>
          <p:spPr>
            <a:xfrm rot="16200000" flipH="1">
              <a:off x="6982564" y="2761756"/>
              <a:ext cx="501957" cy="891760"/>
            </a:xfrm>
            <a:prstGeom prst="bentConnector3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179512" y="711860"/>
              <a:ext cx="8748464" cy="827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251520" y="4464546"/>
              <a:ext cx="8748464" cy="827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/>
            <p:nvPr/>
          </p:nvSpPr>
          <p:spPr>
            <a:xfrm>
              <a:off x="395536" y="4608562"/>
              <a:ext cx="162230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b="1" u="sng" dirty="0"/>
                <a:t>During </a:t>
              </a:r>
              <a:r>
                <a:rPr lang="en-GB" sz="1600" b="1" u="sng" dirty="0" smtClean="0"/>
                <a:t>follow-up</a:t>
              </a:r>
              <a:endParaRPr lang="en-GB" sz="1600" b="1" u="sng" dirty="0"/>
            </a:p>
          </p:txBody>
        </p:sp>
        <p:sp>
          <p:nvSpPr>
            <p:cNvPr id="38" name="Oval 37"/>
            <p:cNvSpPr/>
            <p:nvPr/>
          </p:nvSpPr>
          <p:spPr>
            <a:xfrm>
              <a:off x="6866985" y="1664904"/>
              <a:ext cx="306035" cy="288032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/>
                <a:t>C</a:t>
              </a:r>
              <a:endParaRPr lang="es-PE" sz="20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94209" y="248012"/>
              <a:ext cx="12974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 smtClean="0"/>
                <a:t>Figure 2.4.</a:t>
              </a:r>
              <a:endParaRPr lang="es-PE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51484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8</TotalTime>
  <Words>1523</Words>
  <Application>Microsoft Office PowerPoint</Application>
  <PresentationFormat>Custom</PresentationFormat>
  <Paragraphs>113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 Zetola</dc:creator>
  <cp:lastModifiedBy>Nicola</cp:lastModifiedBy>
  <cp:revision>49</cp:revision>
  <dcterms:created xsi:type="dcterms:W3CDTF">2013-11-18T08:15:38Z</dcterms:created>
  <dcterms:modified xsi:type="dcterms:W3CDTF">2014-06-06T09:20:08Z</dcterms:modified>
</cp:coreProperties>
</file>